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60" r:id="rId2"/>
    <p:sldId id="257" r:id="rId3"/>
    <p:sldId id="258" r:id="rId4"/>
    <p:sldId id="259" r:id="rId5"/>
    <p:sldId id="261" r:id="rId6"/>
    <p:sldId id="262"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C5488"/>
    <a:srgbClr val="DC2B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765"/>
    <p:restoredTop sz="85170"/>
  </p:normalViewPr>
  <p:slideViewPr>
    <p:cSldViewPr snapToGrid="0" snapToObjects="1" showGuides="1">
      <p:cViewPr>
        <p:scale>
          <a:sx n="75" d="100"/>
          <a:sy n="75" d="100"/>
        </p:scale>
        <p:origin x="332" y="-63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iccardo Masina" userId="a1bc6b1a-f4be-41f4-bd72-f2c898d817ca" providerId="ADAL" clId="{C3FFD0B0-59D5-C845-A96A-72FFF02F2236}"/>
    <pc:docChg chg="undo custSel addSld modSld modMainMaster modNotesMaster">
      <pc:chgData name="Riccardo Masina" userId="a1bc6b1a-f4be-41f4-bd72-f2c898d817ca" providerId="ADAL" clId="{C3FFD0B0-59D5-C845-A96A-72FFF02F2236}" dt="2022-11-21T11:39:22.319" v="1072" actId="20577"/>
      <pc:docMkLst>
        <pc:docMk/>
      </pc:docMkLst>
      <pc:sldChg chg="modSp mod modNotes">
        <pc:chgData name="Riccardo Masina" userId="a1bc6b1a-f4be-41f4-bd72-f2c898d817ca" providerId="ADAL" clId="{C3FFD0B0-59D5-C845-A96A-72FFF02F2236}" dt="2022-11-21T11:39:22.319" v="1072" actId="20577"/>
        <pc:sldMkLst>
          <pc:docMk/>
          <pc:sldMk cId="42739390" sldId="257"/>
        </pc:sldMkLst>
        <pc:spChg chg="mod">
          <ac:chgData name="Riccardo Masina" userId="a1bc6b1a-f4be-41f4-bd72-f2c898d817ca" providerId="ADAL" clId="{C3FFD0B0-59D5-C845-A96A-72FFF02F2236}" dt="2022-11-21T11:39:22.319" v="1072" actId="20577"/>
          <ac:spMkLst>
            <pc:docMk/>
            <pc:sldMk cId="42739390" sldId="257"/>
            <ac:spMk id="2" creationId="{9E883060-081C-C344-3C1A-5526352A4CB0}"/>
          </ac:spMkLst>
        </pc:spChg>
        <pc:picChg chg="mod">
          <ac:chgData name="Riccardo Masina" userId="a1bc6b1a-f4be-41f4-bd72-f2c898d817ca" providerId="ADAL" clId="{C3FFD0B0-59D5-C845-A96A-72FFF02F2236}" dt="2022-11-21T10:57:05.238" v="23"/>
          <ac:picMkLst>
            <pc:docMk/>
            <pc:sldMk cId="42739390" sldId="257"/>
            <ac:picMk id="5" creationId="{944A900D-B5D2-1421-8272-59DF02FCC3D1}"/>
          </ac:picMkLst>
        </pc:picChg>
      </pc:sldChg>
      <pc:sldChg chg="modSp mod modNotes">
        <pc:chgData name="Riccardo Masina" userId="a1bc6b1a-f4be-41f4-bd72-f2c898d817ca" providerId="ADAL" clId="{C3FFD0B0-59D5-C845-A96A-72FFF02F2236}" dt="2022-11-21T11:39:18.102" v="1070" actId="20577"/>
        <pc:sldMkLst>
          <pc:docMk/>
          <pc:sldMk cId="4246051860" sldId="258"/>
        </pc:sldMkLst>
        <pc:spChg chg="mod">
          <ac:chgData name="Riccardo Masina" userId="a1bc6b1a-f4be-41f4-bd72-f2c898d817ca" providerId="ADAL" clId="{C3FFD0B0-59D5-C845-A96A-72FFF02F2236}" dt="2022-11-21T11:39:18.102" v="1070" actId="20577"/>
          <ac:spMkLst>
            <pc:docMk/>
            <pc:sldMk cId="4246051860" sldId="258"/>
            <ac:spMk id="2" creationId="{334573E8-89EE-EF25-E8DC-AF87443CFF31}"/>
          </ac:spMkLst>
        </pc:spChg>
        <pc:picChg chg="mod">
          <ac:chgData name="Riccardo Masina" userId="a1bc6b1a-f4be-41f4-bd72-f2c898d817ca" providerId="ADAL" clId="{C3FFD0B0-59D5-C845-A96A-72FFF02F2236}" dt="2022-11-21T10:57:05.238" v="23"/>
          <ac:picMkLst>
            <pc:docMk/>
            <pc:sldMk cId="4246051860" sldId="258"/>
            <ac:picMk id="5" creationId="{C979FEE9-2FE3-5FFE-D93B-66EC70E7EDAE}"/>
          </ac:picMkLst>
        </pc:picChg>
      </pc:sldChg>
      <pc:sldChg chg="modSp mod modNotes">
        <pc:chgData name="Riccardo Masina" userId="a1bc6b1a-f4be-41f4-bd72-f2c898d817ca" providerId="ADAL" clId="{C3FFD0B0-59D5-C845-A96A-72FFF02F2236}" dt="2022-11-21T11:38:48.346" v="1068" actId="20577"/>
        <pc:sldMkLst>
          <pc:docMk/>
          <pc:sldMk cId="1642274118" sldId="259"/>
        </pc:sldMkLst>
        <pc:spChg chg="mod">
          <ac:chgData name="Riccardo Masina" userId="a1bc6b1a-f4be-41f4-bd72-f2c898d817ca" providerId="ADAL" clId="{C3FFD0B0-59D5-C845-A96A-72FFF02F2236}" dt="2022-11-21T11:38:48.346" v="1068" actId="20577"/>
          <ac:spMkLst>
            <pc:docMk/>
            <pc:sldMk cId="1642274118" sldId="259"/>
            <ac:spMk id="2" creationId="{0F85A424-A4A1-8753-AE19-16487562B8B2}"/>
          </ac:spMkLst>
        </pc:spChg>
        <pc:picChg chg="mod">
          <ac:chgData name="Riccardo Masina" userId="a1bc6b1a-f4be-41f4-bd72-f2c898d817ca" providerId="ADAL" clId="{C3FFD0B0-59D5-C845-A96A-72FFF02F2236}" dt="2022-11-21T10:57:05.238" v="23"/>
          <ac:picMkLst>
            <pc:docMk/>
            <pc:sldMk cId="1642274118" sldId="259"/>
            <ac:picMk id="5" creationId="{AF2D1A8A-96A8-B86A-E3A1-49781370E420}"/>
          </ac:picMkLst>
        </pc:picChg>
      </pc:sldChg>
      <pc:sldChg chg="modSp">
        <pc:chgData name="Riccardo Masina" userId="a1bc6b1a-f4be-41f4-bd72-f2c898d817ca" providerId="ADAL" clId="{C3FFD0B0-59D5-C845-A96A-72FFF02F2236}" dt="2022-11-21T10:57:05.238" v="23"/>
        <pc:sldMkLst>
          <pc:docMk/>
          <pc:sldMk cId="3693887694" sldId="260"/>
        </pc:sldMkLst>
        <pc:spChg chg="mod">
          <ac:chgData name="Riccardo Masina" userId="a1bc6b1a-f4be-41f4-bd72-f2c898d817ca" providerId="ADAL" clId="{C3FFD0B0-59D5-C845-A96A-72FFF02F2236}" dt="2022-11-21T10:57:05.238" v="23"/>
          <ac:spMkLst>
            <pc:docMk/>
            <pc:sldMk cId="3693887694" sldId="260"/>
            <ac:spMk id="6" creationId="{19513A57-B7A8-09DB-2AAE-5AFDE2ABA4F0}"/>
          </ac:spMkLst>
        </pc:spChg>
        <pc:picChg chg="mod">
          <ac:chgData name="Riccardo Masina" userId="a1bc6b1a-f4be-41f4-bd72-f2c898d817ca" providerId="ADAL" clId="{C3FFD0B0-59D5-C845-A96A-72FFF02F2236}" dt="2022-11-21T10:57:05.238" v="23"/>
          <ac:picMkLst>
            <pc:docMk/>
            <pc:sldMk cId="3693887694" sldId="260"/>
            <ac:picMk id="5" creationId="{47E3D17B-8802-7A3E-AD9B-EFE128C80F78}"/>
          </ac:picMkLst>
        </pc:picChg>
      </pc:sldChg>
      <pc:sldChg chg="addSp delSp modSp new mod">
        <pc:chgData name="Riccardo Masina" userId="a1bc6b1a-f4be-41f4-bd72-f2c898d817ca" providerId="ADAL" clId="{C3FFD0B0-59D5-C845-A96A-72FFF02F2236}" dt="2022-11-21T11:24:05.092" v="917" actId="1076"/>
        <pc:sldMkLst>
          <pc:docMk/>
          <pc:sldMk cId="1527433029" sldId="261"/>
        </pc:sldMkLst>
        <pc:spChg chg="del mod">
          <ac:chgData name="Riccardo Masina" userId="a1bc6b1a-f4be-41f4-bd72-f2c898d817ca" providerId="ADAL" clId="{C3FFD0B0-59D5-C845-A96A-72FFF02F2236}" dt="2022-11-21T10:53:18.086" v="3" actId="478"/>
          <ac:spMkLst>
            <pc:docMk/>
            <pc:sldMk cId="1527433029" sldId="261"/>
            <ac:spMk id="2" creationId="{64DFED55-6C21-5486-3EAE-E45425AADF89}"/>
          </ac:spMkLst>
        </pc:spChg>
        <pc:spChg chg="del mod">
          <ac:chgData name="Riccardo Masina" userId="a1bc6b1a-f4be-41f4-bd72-f2c898d817ca" providerId="ADAL" clId="{C3FFD0B0-59D5-C845-A96A-72FFF02F2236}" dt="2022-11-21T10:53:20.976" v="5" actId="478"/>
          <ac:spMkLst>
            <pc:docMk/>
            <pc:sldMk cId="1527433029" sldId="261"/>
            <ac:spMk id="3" creationId="{EF2AE560-9B4B-6070-8A7F-6BA4999DC280}"/>
          </ac:spMkLst>
        </pc:spChg>
        <pc:spChg chg="add mod">
          <ac:chgData name="Riccardo Masina" userId="a1bc6b1a-f4be-41f4-bd72-f2c898d817ca" providerId="ADAL" clId="{C3FFD0B0-59D5-C845-A96A-72FFF02F2236}" dt="2022-11-21T11:18:21.986" v="819" actId="14100"/>
          <ac:spMkLst>
            <pc:docMk/>
            <pc:sldMk cId="1527433029" sldId="261"/>
            <ac:spMk id="4" creationId="{4477BC75-D169-2C19-17B8-6482CE5D90F2}"/>
          </ac:spMkLst>
        </pc:spChg>
        <pc:spChg chg="add del mod">
          <ac:chgData name="Riccardo Masina" userId="a1bc6b1a-f4be-41f4-bd72-f2c898d817ca" providerId="ADAL" clId="{C3FFD0B0-59D5-C845-A96A-72FFF02F2236}" dt="2022-11-21T11:22:40.825" v="908" actId="1076"/>
          <ac:spMkLst>
            <pc:docMk/>
            <pc:sldMk cId="1527433029" sldId="261"/>
            <ac:spMk id="7" creationId="{278BAF6B-7807-ED5C-422D-C16FC4F79ACE}"/>
          </ac:spMkLst>
        </pc:spChg>
        <pc:spChg chg="add del mod">
          <ac:chgData name="Riccardo Masina" userId="a1bc6b1a-f4be-41f4-bd72-f2c898d817ca" providerId="ADAL" clId="{C3FFD0B0-59D5-C845-A96A-72FFF02F2236}" dt="2022-11-21T11:22:46.752" v="909" actId="1076"/>
          <ac:spMkLst>
            <pc:docMk/>
            <pc:sldMk cId="1527433029" sldId="261"/>
            <ac:spMk id="8" creationId="{3CB63B93-E4C9-4FD8-B77C-1649EE5A8386}"/>
          </ac:spMkLst>
        </pc:spChg>
        <pc:spChg chg="add del mod">
          <ac:chgData name="Riccardo Masina" userId="a1bc6b1a-f4be-41f4-bd72-f2c898d817ca" providerId="ADAL" clId="{C3FFD0B0-59D5-C845-A96A-72FFF02F2236}" dt="2022-11-21T11:22:53.753" v="910" actId="1076"/>
          <ac:spMkLst>
            <pc:docMk/>
            <pc:sldMk cId="1527433029" sldId="261"/>
            <ac:spMk id="9" creationId="{60E54C05-70DB-57AA-2CF9-668366150D5D}"/>
          </ac:spMkLst>
        </pc:spChg>
        <pc:spChg chg="add del mod">
          <ac:chgData name="Riccardo Masina" userId="a1bc6b1a-f4be-41f4-bd72-f2c898d817ca" providerId="ADAL" clId="{C3FFD0B0-59D5-C845-A96A-72FFF02F2236}" dt="2022-11-21T11:23:04.610" v="911" actId="1076"/>
          <ac:spMkLst>
            <pc:docMk/>
            <pc:sldMk cId="1527433029" sldId="261"/>
            <ac:spMk id="10" creationId="{D6FEE001-B633-2AE5-009F-F80E7BD395B3}"/>
          </ac:spMkLst>
        </pc:spChg>
        <pc:spChg chg="add del mod">
          <ac:chgData name="Riccardo Masina" userId="a1bc6b1a-f4be-41f4-bd72-f2c898d817ca" providerId="ADAL" clId="{C3FFD0B0-59D5-C845-A96A-72FFF02F2236}" dt="2022-11-21T11:23:19.714" v="912" actId="1076"/>
          <ac:spMkLst>
            <pc:docMk/>
            <pc:sldMk cId="1527433029" sldId="261"/>
            <ac:spMk id="11" creationId="{93B98365-C48B-35DD-6957-59E2E40681DE}"/>
          </ac:spMkLst>
        </pc:spChg>
        <pc:spChg chg="add del mod">
          <ac:chgData name="Riccardo Masina" userId="a1bc6b1a-f4be-41f4-bd72-f2c898d817ca" providerId="ADAL" clId="{C3FFD0B0-59D5-C845-A96A-72FFF02F2236}" dt="2022-11-21T11:23:32.124" v="913" actId="1076"/>
          <ac:spMkLst>
            <pc:docMk/>
            <pc:sldMk cId="1527433029" sldId="261"/>
            <ac:spMk id="12" creationId="{C7DB11C1-0E98-B336-ADF0-F3A734A1E67D}"/>
          </ac:spMkLst>
        </pc:spChg>
        <pc:spChg chg="add del mod">
          <ac:chgData name="Riccardo Masina" userId="a1bc6b1a-f4be-41f4-bd72-f2c898d817ca" providerId="ADAL" clId="{C3FFD0B0-59D5-C845-A96A-72FFF02F2236}" dt="2022-11-21T11:23:43.635" v="914" actId="1076"/>
          <ac:spMkLst>
            <pc:docMk/>
            <pc:sldMk cId="1527433029" sldId="261"/>
            <ac:spMk id="13" creationId="{3D5AE033-5515-FF76-B387-673D561F655C}"/>
          </ac:spMkLst>
        </pc:spChg>
        <pc:spChg chg="add del mod">
          <ac:chgData name="Riccardo Masina" userId="a1bc6b1a-f4be-41f4-bd72-f2c898d817ca" providerId="ADAL" clId="{C3FFD0B0-59D5-C845-A96A-72FFF02F2236}" dt="2022-11-21T11:23:52.764" v="915" actId="1076"/>
          <ac:spMkLst>
            <pc:docMk/>
            <pc:sldMk cId="1527433029" sldId="261"/>
            <ac:spMk id="14" creationId="{618036DB-1E63-B54D-13CE-5FE12B6AC84F}"/>
          </ac:spMkLst>
        </pc:spChg>
        <pc:spChg chg="add del mod">
          <ac:chgData name="Riccardo Masina" userId="a1bc6b1a-f4be-41f4-bd72-f2c898d817ca" providerId="ADAL" clId="{C3FFD0B0-59D5-C845-A96A-72FFF02F2236}" dt="2022-11-21T11:23:58.948" v="916" actId="1076"/>
          <ac:spMkLst>
            <pc:docMk/>
            <pc:sldMk cId="1527433029" sldId="261"/>
            <ac:spMk id="15" creationId="{B2B65161-8CA4-A1E5-6A8D-10AA05499198}"/>
          </ac:spMkLst>
        </pc:spChg>
        <pc:spChg chg="add del mod">
          <ac:chgData name="Riccardo Masina" userId="a1bc6b1a-f4be-41f4-bd72-f2c898d817ca" providerId="ADAL" clId="{C3FFD0B0-59D5-C845-A96A-72FFF02F2236}" dt="2022-11-21T11:24:05.092" v="917" actId="1076"/>
          <ac:spMkLst>
            <pc:docMk/>
            <pc:sldMk cId="1527433029" sldId="261"/>
            <ac:spMk id="16" creationId="{790783CB-689A-3A7F-0FC7-836E1E2B8713}"/>
          </ac:spMkLst>
        </pc:spChg>
        <pc:spChg chg="add del mod">
          <ac:chgData name="Riccardo Masina" userId="a1bc6b1a-f4be-41f4-bd72-f2c898d817ca" providerId="ADAL" clId="{C3FFD0B0-59D5-C845-A96A-72FFF02F2236}" dt="2022-11-21T11:22:01.276" v="901"/>
          <ac:spMkLst>
            <pc:docMk/>
            <pc:sldMk cId="1527433029" sldId="261"/>
            <ac:spMk id="18" creationId="{41F0403E-B2FB-C9B3-F4D9-476EE0F58F77}"/>
          </ac:spMkLst>
        </pc:spChg>
        <pc:spChg chg="add del mod">
          <ac:chgData name="Riccardo Masina" userId="a1bc6b1a-f4be-41f4-bd72-f2c898d817ca" providerId="ADAL" clId="{C3FFD0B0-59D5-C845-A96A-72FFF02F2236}" dt="2022-11-21T11:22:01.276" v="901"/>
          <ac:spMkLst>
            <pc:docMk/>
            <pc:sldMk cId="1527433029" sldId="261"/>
            <ac:spMk id="19" creationId="{847DFF4B-1CCE-5892-C59E-814E65DE8FD3}"/>
          </ac:spMkLst>
        </pc:spChg>
        <pc:spChg chg="add del mod">
          <ac:chgData name="Riccardo Masina" userId="a1bc6b1a-f4be-41f4-bd72-f2c898d817ca" providerId="ADAL" clId="{C3FFD0B0-59D5-C845-A96A-72FFF02F2236}" dt="2022-11-21T11:22:01.276" v="901"/>
          <ac:spMkLst>
            <pc:docMk/>
            <pc:sldMk cId="1527433029" sldId="261"/>
            <ac:spMk id="20" creationId="{37ED4DB7-4325-7F6F-2EB5-DF23D1D4D064}"/>
          </ac:spMkLst>
        </pc:spChg>
        <pc:spChg chg="add del mod">
          <ac:chgData name="Riccardo Masina" userId="a1bc6b1a-f4be-41f4-bd72-f2c898d817ca" providerId="ADAL" clId="{C3FFD0B0-59D5-C845-A96A-72FFF02F2236}" dt="2022-11-21T11:22:01.276" v="901"/>
          <ac:spMkLst>
            <pc:docMk/>
            <pc:sldMk cId="1527433029" sldId="261"/>
            <ac:spMk id="21" creationId="{C1C5F1B0-E3A0-BD49-CB96-36ACC1672176}"/>
          </ac:spMkLst>
        </pc:spChg>
        <pc:spChg chg="add del mod">
          <ac:chgData name="Riccardo Masina" userId="a1bc6b1a-f4be-41f4-bd72-f2c898d817ca" providerId="ADAL" clId="{C3FFD0B0-59D5-C845-A96A-72FFF02F2236}" dt="2022-11-21T11:22:01.276" v="901"/>
          <ac:spMkLst>
            <pc:docMk/>
            <pc:sldMk cId="1527433029" sldId="261"/>
            <ac:spMk id="22" creationId="{A109108C-7F5E-9BBC-510B-B979AA300C7F}"/>
          </ac:spMkLst>
        </pc:spChg>
        <pc:spChg chg="add del mod">
          <ac:chgData name="Riccardo Masina" userId="a1bc6b1a-f4be-41f4-bd72-f2c898d817ca" providerId="ADAL" clId="{C3FFD0B0-59D5-C845-A96A-72FFF02F2236}" dt="2022-11-21T11:22:01.276" v="901"/>
          <ac:spMkLst>
            <pc:docMk/>
            <pc:sldMk cId="1527433029" sldId="261"/>
            <ac:spMk id="23" creationId="{06661263-1616-A067-9317-A5C06BA8E5F4}"/>
          </ac:spMkLst>
        </pc:spChg>
        <pc:spChg chg="add del mod">
          <ac:chgData name="Riccardo Masina" userId="a1bc6b1a-f4be-41f4-bd72-f2c898d817ca" providerId="ADAL" clId="{C3FFD0B0-59D5-C845-A96A-72FFF02F2236}" dt="2022-11-21T11:22:01.276" v="901"/>
          <ac:spMkLst>
            <pc:docMk/>
            <pc:sldMk cId="1527433029" sldId="261"/>
            <ac:spMk id="24" creationId="{7BB2D995-B8FB-80E8-6C03-31BC9D4AF229}"/>
          </ac:spMkLst>
        </pc:spChg>
        <pc:spChg chg="add del mod">
          <ac:chgData name="Riccardo Masina" userId="a1bc6b1a-f4be-41f4-bd72-f2c898d817ca" providerId="ADAL" clId="{C3FFD0B0-59D5-C845-A96A-72FFF02F2236}" dt="2022-11-21T11:22:01.276" v="901"/>
          <ac:spMkLst>
            <pc:docMk/>
            <pc:sldMk cId="1527433029" sldId="261"/>
            <ac:spMk id="25" creationId="{6A1A109E-E3B3-E021-692E-BE204F0BE3A9}"/>
          </ac:spMkLst>
        </pc:spChg>
        <pc:spChg chg="add del mod">
          <ac:chgData name="Riccardo Masina" userId="a1bc6b1a-f4be-41f4-bd72-f2c898d817ca" providerId="ADAL" clId="{C3FFD0B0-59D5-C845-A96A-72FFF02F2236}" dt="2022-11-21T11:22:01.276" v="901"/>
          <ac:spMkLst>
            <pc:docMk/>
            <pc:sldMk cId="1527433029" sldId="261"/>
            <ac:spMk id="26" creationId="{69D27B7E-B852-1EC2-EE04-E5F41E32ACED}"/>
          </ac:spMkLst>
        </pc:spChg>
        <pc:spChg chg="add del mod">
          <ac:chgData name="Riccardo Masina" userId="a1bc6b1a-f4be-41f4-bd72-f2c898d817ca" providerId="ADAL" clId="{C3FFD0B0-59D5-C845-A96A-72FFF02F2236}" dt="2022-11-21T11:22:01.276" v="901"/>
          <ac:spMkLst>
            <pc:docMk/>
            <pc:sldMk cId="1527433029" sldId="261"/>
            <ac:spMk id="27" creationId="{7928A1D6-38CB-41FD-6F9C-92BDD055ADF8}"/>
          </ac:spMkLst>
        </pc:spChg>
        <pc:picChg chg="add del mod">
          <ac:chgData name="Riccardo Masina" userId="a1bc6b1a-f4be-41f4-bd72-f2c898d817ca" providerId="ADAL" clId="{C3FFD0B0-59D5-C845-A96A-72FFF02F2236}" dt="2022-11-21T11:22:32.901" v="907" actId="1076"/>
          <ac:picMkLst>
            <pc:docMk/>
            <pc:sldMk cId="1527433029" sldId="261"/>
            <ac:picMk id="6" creationId="{2A984075-6585-47DD-06E0-429DABB9F36D}"/>
          </ac:picMkLst>
        </pc:picChg>
        <pc:picChg chg="add del mod">
          <ac:chgData name="Riccardo Masina" userId="a1bc6b1a-f4be-41f4-bd72-f2c898d817ca" providerId="ADAL" clId="{C3FFD0B0-59D5-C845-A96A-72FFF02F2236}" dt="2022-11-21T11:22:01.276" v="901"/>
          <ac:picMkLst>
            <pc:docMk/>
            <pc:sldMk cId="1527433029" sldId="261"/>
            <ac:picMk id="17" creationId="{3299097B-13F7-9B5F-CBB5-E8E4967BA294}"/>
          </ac:picMkLst>
        </pc:picChg>
        <pc:picChg chg="add del">
          <ac:chgData name="Riccardo Masina" userId="a1bc6b1a-f4be-41f4-bd72-f2c898d817ca" providerId="ADAL" clId="{C3FFD0B0-59D5-C845-A96A-72FFF02F2236}" dt="2022-11-21T11:22:09.239" v="903"/>
          <ac:picMkLst>
            <pc:docMk/>
            <pc:sldMk cId="1527433029" sldId="261"/>
            <ac:picMk id="28" creationId="{D81A99CC-A658-C613-E3E5-4FB372272366}"/>
          </ac:picMkLst>
        </pc:picChg>
      </pc:sldChg>
      <pc:sldChg chg="addSp delSp modSp new mod">
        <pc:chgData name="Riccardo Masina" userId="a1bc6b1a-f4be-41f4-bd72-f2c898d817ca" providerId="ADAL" clId="{C3FFD0B0-59D5-C845-A96A-72FFF02F2236}" dt="2022-11-21T11:17:51.160" v="816" actId="113"/>
        <pc:sldMkLst>
          <pc:docMk/>
          <pc:sldMk cId="3292778453" sldId="262"/>
        </pc:sldMkLst>
        <pc:spChg chg="del">
          <ac:chgData name="Riccardo Masina" userId="a1bc6b1a-f4be-41f4-bd72-f2c898d817ca" providerId="ADAL" clId="{C3FFD0B0-59D5-C845-A96A-72FFF02F2236}" dt="2022-11-21T10:57:50.796" v="28" actId="478"/>
          <ac:spMkLst>
            <pc:docMk/>
            <pc:sldMk cId="3292778453" sldId="262"/>
            <ac:spMk id="2" creationId="{B48D0C58-EF36-0E0A-2B3D-0406743B1E93}"/>
          </ac:spMkLst>
        </pc:spChg>
        <pc:spChg chg="del">
          <ac:chgData name="Riccardo Masina" userId="a1bc6b1a-f4be-41f4-bd72-f2c898d817ca" providerId="ADAL" clId="{C3FFD0B0-59D5-C845-A96A-72FFF02F2236}" dt="2022-11-21T10:57:51.917" v="29" actId="478"/>
          <ac:spMkLst>
            <pc:docMk/>
            <pc:sldMk cId="3292778453" sldId="262"/>
            <ac:spMk id="3" creationId="{02E9FB7B-B960-F6E5-3212-1CA4E238DD0E}"/>
          </ac:spMkLst>
        </pc:spChg>
        <pc:spChg chg="add mod">
          <ac:chgData name="Riccardo Masina" userId="a1bc6b1a-f4be-41f4-bd72-f2c898d817ca" providerId="ADAL" clId="{C3FFD0B0-59D5-C845-A96A-72FFF02F2236}" dt="2022-11-21T11:06:19.229" v="169" actId="1036"/>
          <ac:spMkLst>
            <pc:docMk/>
            <pc:sldMk cId="3292778453" sldId="262"/>
            <ac:spMk id="5" creationId="{09C2A1B7-C5EB-AA0E-1E15-27A3CDE6A1B7}"/>
          </ac:spMkLst>
        </pc:spChg>
        <pc:spChg chg="add mod">
          <ac:chgData name="Riccardo Masina" userId="a1bc6b1a-f4be-41f4-bd72-f2c898d817ca" providerId="ADAL" clId="{C3FFD0B0-59D5-C845-A96A-72FFF02F2236}" dt="2022-11-21T11:08:36.728" v="282" actId="1076"/>
          <ac:spMkLst>
            <pc:docMk/>
            <pc:sldMk cId="3292778453" sldId="262"/>
            <ac:spMk id="8" creationId="{4CE29AD2-583B-AB4D-6447-575505F1AEA8}"/>
          </ac:spMkLst>
        </pc:spChg>
        <pc:spChg chg="add del mod">
          <ac:chgData name="Riccardo Masina" userId="a1bc6b1a-f4be-41f4-bd72-f2c898d817ca" providerId="ADAL" clId="{C3FFD0B0-59D5-C845-A96A-72FFF02F2236}" dt="2022-11-21T11:02:15.603" v="65" actId="478"/>
          <ac:spMkLst>
            <pc:docMk/>
            <pc:sldMk cId="3292778453" sldId="262"/>
            <ac:spMk id="9" creationId="{5F6DE830-B04B-143E-3B5A-9153DF4536D4}"/>
          </ac:spMkLst>
        </pc:spChg>
        <pc:spChg chg="add mod">
          <ac:chgData name="Riccardo Masina" userId="a1bc6b1a-f4be-41f4-bd72-f2c898d817ca" providerId="ADAL" clId="{C3FFD0B0-59D5-C845-A96A-72FFF02F2236}" dt="2022-11-21T11:08:36.728" v="282" actId="1076"/>
          <ac:spMkLst>
            <pc:docMk/>
            <pc:sldMk cId="3292778453" sldId="262"/>
            <ac:spMk id="10" creationId="{94C0A8CA-8263-FAE6-2512-77B5CA35901F}"/>
          </ac:spMkLst>
        </pc:spChg>
        <pc:spChg chg="add mod">
          <ac:chgData name="Riccardo Masina" userId="a1bc6b1a-f4be-41f4-bd72-f2c898d817ca" providerId="ADAL" clId="{C3FFD0B0-59D5-C845-A96A-72FFF02F2236}" dt="2022-11-21T11:08:36.728" v="282" actId="1076"/>
          <ac:spMkLst>
            <pc:docMk/>
            <pc:sldMk cId="3292778453" sldId="262"/>
            <ac:spMk id="11" creationId="{9BA4438C-51F1-9E11-9EA1-8EEB0EDF7E6D}"/>
          </ac:spMkLst>
        </pc:spChg>
        <pc:spChg chg="add mod">
          <ac:chgData name="Riccardo Masina" userId="a1bc6b1a-f4be-41f4-bd72-f2c898d817ca" providerId="ADAL" clId="{C3FFD0B0-59D5-C845-A96A-72FFF02F2236}" dt="2022-11-21T11:08:36.728" v="282" actId="1076"/>
          <ac:spMkLst>
            <pc:docMk/>
            <pc:sldMk cId="3292778453" sldId="262"/>
            <ac:spMk id="12" creationId="{ED91EAD1-292D-39B2-AD97-4FD26DDB592E}"/>
          </ac:spMkLst>
        </pc:spChg>
        <pc:spChg chg="add mod">
          <ac:chgData name="Riccardo Masina" userId="a1bc6b1a-f4be-41f4-bd72-f2c898d817ca" providerId="ADAL" clId="{C3FFD0B0-59D5-C845-A96A-72FFF02F2236}" dt="2022-11-21T11:08:36.728" v="282" actId="1076"/>
          <ac:spMkLst>
            <pc:docMk/>
            <pc:sldMk cId="3292778453" sldId="262"/>
            <ac:spMk id="13" creationId="{BA86B1B7-1666-D28E-39B3-E7EEE2D59DCE}"/>
          </ac:spMkLst>
        </pc:spChg>
        <pc:spChg chg="add mod">
          <ac:chgData name="Riccardo Masina" userId="a1bc6b1a-f4be-41f4-bd72-f2c898d817ca" providerId="ADAL" clId="{C3FFD0B0-59D5-C845-A96A-72FFF02F2236}" dt="2022-11-21T11:08:36.728" v="282" actId="1076"/>
          <ac:spMkLst>
            <pc:docMk/>
            <pc:sldMk cId="3292778453" sldId="262"/>
            <ac:spMk id="14" creationId="{CFC17730-6288-7D3E-FCBD-44CE93E9EADF}"/>
          </ac:spMkLst>
        </pc:spChg>
        <pc:spChg chg="add mod">
          <ac:chgData name="Riccardo Masina" userId="a1bc6b1a-f4be-41f4-bd72-f2c898d817ca" providerId="ADAL" clId="{C3FFD0B0-59D5-C845-A96A-72FFF02F2236}" dt="2022-11-21T11:08:36.728" v="282" actId="1076"/>
          <ac:spMkLst>
            <pc:docMk/>
            <pc:sldMk cId="3292778453" sldId="262"/>
            <ac:spMk id="15" creationId="{E3A71FD1-0FCE-C757-50E8-96BFEFD527E8}"/>
          </ac:spMkLst>
        </pc:spChg>
        <pc:spChg chg="add mod">
          <ac:chgData name="Riccardo Masina" userId="a1bc6b1a-f4be-41f4-bd72-f2c898d817ca" providerId="ADAL" clId="{C3FFD0B0-59D5-C845-A96A-72FFF02F2236}" dt="2022-11-21T11:08:36.728" v="282" actId="1076"/>
          <ac:spMkLst>
            <pc:docMk/>
            <pc:sldMk cId="3292778453" sldId="262"/>
            <ac:spMk id="16" creationId="{810D93DF-34C9-42D0-47B4-BE0C4B4DFA29}"/>
          </ac:spMkLst>
        </pc:spChg>
        <pc:spChg chg="add del mod">
          <ac:chgData name="Riccardo Masina" userId="a1bc6b1a-f4be-41f4-bd72-f2c898d817ca" providerId="ADAL" clId="{C3FFD0B0-59D5-C845-A96A-72FFF02F2236}" dt="2022-11-21T11:07:38.163" v="236"/>
          <ac:spMkLst>
            <pc:docMk/>
            <pc:sldMk cId="3292778453" sldId="262"/>
            <ac:spMk id="17" creationId="{D68B5D94-CFDF-B497-2F67-458FD7D22B75}"/>
          </ac:spMkLst>
        </pc:spChg>
        <pc:spChg chg="add mod">
          <ac:chgData name="Riccardo Masina" userId="a1bc6b1a-f4be-41f4-bd72-f2c898d817ca" providerId="ADAL" clId="{C3FFD0B0-59D5-C845-A96A-72FFF02F2236}" dt="2022-11-21T11:17:51.160" v="816" actId="113"/>
          <ac:spMkLst>
            <pc:docMk/>
            <pc:sldMk cId="3292778453" sldId="262"/>
            <ac:spMk id="18" creationId="{45859FA5-DD93-22A2-F466-0AD246031942}"/>
          </ac:spMkLst>
        </pc:spChg>
        <pc:picChg chg="add mod">
          <ac:chgData name="Riccardo Masina" userId="a1bc6b1a-f4be-41f4-bd72-f2c898d817ca" providerId="ADAL" clId="{C3FFD0B0-59D5-C845-A96A-72FFF02F2236}" dt="2022-11-21T11:08:36.728" v="282" actId="1076"/>
          <ac:picMkLst>
            <pc:docMk/>
            <pc:sldMk cId="3292778453" sldId="262"/>
            <ac:picMk id="7" creationId="{12832BCE-7F6F-CEBE-88B4-4133C8CAFA24}"/>
          </ac:picMkLst>
        </pc:picChg>
      </pc:sldChg>
      <pc:sldMasterChg chg="modSp modSldLayout">
        <pc:chgData name="Riccardo Masina" userId="a1bc6b1a-f4be-41f4-bd72-f2c898d817ca" providerId="ADAL" clId="{C3FFD0B0-59D5-C845-A96A-72FFF02F2236}" dt="2022-11-21T10:57:05.238" v="23"/>
        <pc:sldMasterMkLst>
          <pc:docMk/>
          <pc:sldMasterMk cId="543221463" sldId="2147483648"/>
        </pc:sldMasterMkLst>
        <pc:spChg chg="mod">
          <ac:chgData name="Riccardo Masina" userId="a1bc6b1a-f4be-41f4-bd72-f2c898d817ca" providerId="ADAL" clId="{C3FFD0B0-59D5-C845-A96A-72FFF02F2236}" dt="2022-11-21T10:57:05.238" v="23"/>
          <ac:spMkLst>
            <pc:docMk/>
            <pc:sldMasterMk cId="543221463" sldId="2147483648"/>
            <ac:spMk id="2" creationId="{5F9A9172-7D18-5FB6-ED23-AF89CAE20C54}"/>
          </ac:spMkLst>
        </pc:spChg>
        <pc:spChg chg="mod">
          <ac:chgData name="Riccardo Masina" userId="a1bc6b1a-f4be-41f4-bd72-f2c898d817ca" providerId="ADAL" clId="{C3FFD0B0-59D5-C845-A96A-72FFF02F2236}" dt="2022-11-21T10:57:05.238" v="23"/>
          <ac:spMkLst>
            <pc:docMk/>
            <pc:sldMasterMk cId="543221463" sldId="2147483648"/>
            <ac:spMk id="3" creationId="{FFC49BDD-69B7-92BA-2044-CDA31548BC8F}"/>
          </ac:spMkLst>
        </pc:spChg>
        <pc:spChg chg="mod">
          <ac:chgData name="Riccardo Masina" userId="a1bc6b1a-f4be-41f4-bd72-f2c898d817ca" providerId="ADAL" clId="{C3FFD0B0-59D5-C845-A96A-72FFF02F2236}" dt="2022-11-21T10:57:05.238" v="23"/>
          <ac:spMkLst>
            <pc:docMk/>
            <pc:sldMasterMk cId="543221463" sldId="2147483648"/>
            <ac:spMk id="4" creationId="{167B9FF6-6A40-D51B-32C0-FEAC439C173E}"/>
          </ac:spMkLst>
        </pc:spChg>
        <pc:spChg chg="mod">
          <ac:chgData name="Riccardo Masina" userId="a1bc6b1a-f4be-41f4-bd72-f2c898d817ca" providerId="ADAL" clId="{C3FFD0B0-59D5-C845-A96A-72FFF02F2236}" dt="2022-11-21T10:57:05.238" v="23"/>
          <ac:spMkLst>
            <pc:docMk/>
            <pc:sldMasterMk cId="543221463" sldId="2147483648"/>
            <ac:spMk id="5" creationId="{08AAD9FF-098C-575F-7EFB-0889B9FD2A25}"/>
          </ac:spMkLst>
        </pc:spChg>
        <pc:spChg chg="mod">
          <ac:chgData name="Riccardo Masina" userId="a1bc6b1a-f4be-41f4-bd72-f2c898d817ca" providerId="ADAL" clId="{C3FFD0B0-59D5-C845-A96A-72FFF02F2236}" dt="2022-11-21T10:57:05.238" v="23"/>
          <ac:spMkLst>
            <pc:docMk/>
            <pc:sldMasterMk cId="543221463" sldId="2147483648"/>
            <ac:spMk id="6" creationId="{1C678393-9679-F0C0-67B9-8763D58B89C5}"/>
          </ac:spMkLst>
        </pc:spChg>
        <pc:sldLayoutChg chg="modSp">
          <pc:chgData name="Riccardo Masina" userId="a1bc6b1a-f4be-41f4-bd72-f2c898d817ca" providerId="ADAL" clId="{C3FFD0B0-59D5-C845-A96A-72FFF02F2236}" dt="2022-11-21T10:57:05.238" v="23"/>
          <pc:sldLayoutMkLst>
            <pc:docMk/>
            <pc:sldMasterMk cId="543221463" sldId="2147483648"/>
            <pc:sldLayoutMk cId="3422918560" sldId="2147483649"/>
          </pc:sldLayoutMkLst>
          <pc:spChg chg="mod">
            <ac:chgData name="Riccardo Masina" userId="a1bc6b1a-f4be-41f4-bd72-f2c898d817ca" providerId="ADAL" clId="{C3FFD0B0-59D5-C845-A96A-72FFF02F2236}" dt="2022-11-21T10:57:05.238" v="23"/>
            <ac:spMkLst>
              <pc:docMk/>
              <pc:sldMasterMk cId="543221463" sldId="2147483648"/>
              <pc:sldLayoutMk cId="3422918560" sldId="2147483649"/>
              <ac:spMk id="2" creationId="{BB1832E5-A74C-E42F-8E98-1C5BE9D3D761}"/>
            </ac:spMkLst>
          </pc:spChg>
          <pc:spChg chg="mod">
            <ac:chgData name="Riccardo Masina" userId="a1bc6b1a-f4be-41f4-bd72-f2c898d817ca" providerId="ADAL" clId="{C3FFD0B0-59D5-C845-A96A-72FFF02F2236}" dt="2022-11-21T10:57:05.238" v="23"/>
            <ac:spMkLst>
              <pc:docMk/>
              <pc:sldMasterMk cId="543221463" sldId="2147483648"/>
              <pc:sldLayoutMk cId="3422918560" sldId="2147483649"/>
              <ac:spMk id="3" creationId="{123E35CC-00FA-EE45-31DA-ACBE0CE334D0}"/>
            </ac:spMkLst>
          </pc:spChg>
        </pc:sldLayoutChg>
        <pc:sldLayoutChg chg="modSp">
          <pc:chgData name="Riccardo Masina" userId="a1bc6b1a-f4be-41f4-bd72-f2c898d817ca" providerId="ADAL" clId="{C3FFD0B0-59D5-C845-A96A-72FFF02F2236}" dt="2022-11-21T10:57:05.238" v="23"/>
          <pc:sldLayoutMkLst>
            <pc:docMk/>
            <pc:sldMasterMk cId="543221463" sldId="2147483648"/>
            <pc:sldLayoutMk cId="1848985528" sldId="2147483651"/>
          </pc:sldLayoutMkLst>
          <pc:spChg chg="mod">
            <ac:chgData name="Riccardo Masina" userId="a1bc6b1a-f4be-41f4-bd72-f2c898d817ca" providerId="ADAL" clId="{C3FFD0B0-59D5-C845-A96A-72FFF02F2236}" dt="2022-11-21T10:57:05.238" v="23"/>
            <ac:spMkLst>
              <pc:docMk/>
              <pc:sldMasterMk cId="543221463" sldId="2147483648"/>
              <pc:sldLayoutMk cId="1848985528" sldId="2147483651"/>
              <ac:spMk id="2" creationId="{0811468B-489F-D176-42BC-F8D7762FB80D}"/>
            </ac:spMkLst>
          </pc:spChg>
          <pc:spChg chg="mod">
            <ac:chgData name="Riccardo Masina" userId="a1bc6b1a-f4be-41f4-bd72-f2c898d817ca" providerId="ADAL" clId="{C3FFD0B0-59D5-C845-A96A-72FFF02F2236}" dt="2022-11-21T10:57:05.238" v="23"/>
            <ac:spMkLst>
              <pc:docMk/>
              <pc:sldMasterMk cId="543221463" sldId="2147483648"/>
              <pc:sldLayoutMk cId="1848985528" sldId="2147483651"/>
              <ac:spMk id="3" creationId="{8590627C-D0A4-E821-57EA-4BE598D35C3D}"/>
            </ac:spMkLst>
          </pc:spChg>
        </pc:sldLayoutChg>
        <pc:sldLayoutChg chg="modSp">
          <pc:chgData name="Riccardo Masina" userId="a1bc6b1a-f4be-41f4-bd72-f2c898d817ca" providerId="ADAL" clId="{C3FFD0B0-59D5-C845-A96A-72FFF02F2236}" dt="2022-11-21T10:57:05.238" v="23"/>
          <pc:sldLayoutMkLst>
            <pc:docMk/>
            <pc:sldMasterMk cId="543221463" sldId="2147483648"/>
            <pc:sldLayoutMk cId="1514086271" sldId="2147483652"/>
          </pc:sldLayoutMkLst>
          <pc:spChg chg="mod">
            <ac:chgData name="Riccardo Masina" userId="a1bc6b1a-f4be-41f4-bd72-f2c898d817ca" providerId="ADAL" clId="{C3FFD0B0-59D5-C845-A96A-72FFF02F2236}" dt="2022-11-21T10:57:05.238" v="23"/>
            <ac:spMkLst>
              <pc:docMk/>
              <pc:sldMasterMk cId="543221463" sldId="2147483648"/>
              <pc:sldLayoutMk cId="1514086271" sldId="2147483652"/>
              <ac:spMk id="3" creationId="{02CAC68B-8534-BFD1-D089-F10A3E0E5CCC}"/>
            </ac:spMkLst>
          </pc:spChg>
          <pc:spChg chg="mod">
            <ac:chgData name="Riccardo Masina" userId="a1bc6b1a-f4be-41f4-bd72-f2c898d817ca" providerId="ADAL" clId="{C3FFD0B0-59D5-C845-A96A-72FFF02F2236}" dt="2022-11-21T10:57:05.238" v="23"/>
            <ac:spMkLst>
              <pc:docMk/>
              <pc:sldMasterMk cId="543221463" sldId="2147483648"/>
              <pc:sldLayoutMk cId="1514086271" sldId="2147483652"/>
              <ac:spMk id="4" creationId="{E9E70DDE-0727-87FE-DD1B-2C67E08D538B}"/>
            </ac:spMkLst>
          </pc:spChg>
        </pc:sldLayoutChg>
        <pc:sldLayoutChg chg="modSp">
          <pc:chgData name="Riccardo Masina" userId="a1bc6b1a-f4be-41f4-bd72-f2c898d817ca" providerId="ADAL" clId="{C3FFD0B0-59D5-C845-A96A-72FFF02F2236}" dt="2022-11-21T10:57:05.238" v="23"/>
          <pc:sldLayoutMkLst>
            <pc:docMk/>
            <pc:sldMasterMk cId="543221463" sldId="2147483648"/>
            <pc:sldLayoutMk cId="92452697" sldId="2147483653"/>
          </pc:sldLayoutMkLst>
          <pc:spChg chg="mod">
            <ac:chgData name="Riccardo Masina" userId="a1bc6b1a-f4be-41f4-bd72-f2c898d817ca" providerId="ADAL" clId="{C3FFD0B0-59D5-C845-A96A-72FFF02F2236}" dt="2022-11-21T10:57:05.238" v="23"/>
            <ac:spMkLst>
              <pc:docMk/>
              <pc:sldMasterMk cId="543221463" sldId="2147483648"/>
              <pc:sldLayoutMk cId="92452697" sldId="2147483653"/>
              <ac:spMk id="2" creationId="{5E1A8887-5598-3FB8-1326-917EFDAD40C3}"/>
            </ac:spMkLst>
          </pc:spChg>
          <pc:spChg chg="mod">
            <ac:chgData name="Riccardo Masina" userId="a1bc6b1a-f4be-41f4-bd72-f2c898d817ca" providerId="ADAL" clId="{C3FFD0B0-59D5-C845-A96A-72FFF02F2236}" dt="2022-11-21T10:57:05.238" v="23"/>
            <ac:spMkLst>
              <pc:docMk/>
              <pc:sldMasterMk cId="543221463" sldId="2147483648"/>
              <pc:sldLayoutMk cId="92452697" sldId="2147483653"/>
              <ac:spMk id="3" creationId="{2236D473-A511-B62F-1DDF-368385664956}"/>
            </ac:spMkLst>
          </pc:spChg>
          <pc:spChg chg="mod">
            <ac:chgData name="Riccardo Masina" userId="a1bc6b1a-f4be-41f4-bd72-f2c898d817ca" providerId="ADAL" clId="{C3FFD0B0-59D5-C845-A96A-72FFF02F2236}" dt="2022-11-21T10:57:05.238" v="23"/>
            <ac:spMkLst>
              <pc:docMk/>
              <pc:sldMasterMk cId="543221463" sldId="2147483648"/>
              <pc:sldLayoutMk cId="92452697" sldId="2147483653"/>
              <ac:spMk id="4" creationId="{FF9F36D6-9DBB-5608-6E65-29EAA77DED7E}"/>
            </ac:spMkLst>
          </pc:spChg>
          <pc:spChg chg="mod">
            <ac:chgData name="Riccardo Masina" userId="a1bc6b1a-f4be-41f4-bd72-f2c898d817ca" providerId="ADAL" clId="{C3FFD0B0-59D5-C845-A96A-72FFF02F2236}" dt="2022-11-21T10:57:05.238" v="23"/>
            <ac:spMkLst>
              <pc:docMk/>
              <pc:sldMasterMk cId="543221463" sldId="2147483648"/>
              <pc:sldLayoutMk cId="92452697" sldId="2147483653"/>
              <ac:spMk id="5" creationId="{353F4A0A-A2BC-BACE-875C-AF013F318C86}"/>
            </ac:spMkLst>
          </pc:spChg>
          <pc:spChg chg="mod">
            <ac:chgData name="Riccardo Masina" userId="a1bc6b1a-f4be-41f4-bd72-f2c898d817ca" providerId="ADAL" clId="{C3FFD0B0-59D5-C845-A96A-72FFF02F2236}" dt="2022-11-21T10:57:05.238" v="23"/>
            <ac:spMkLst>
              <pc:docMk/>
              <pc:sldMasterMk cId="543221463" sldId="2147483648"/>
              <pc:sldLayoutMk cId="92452697" sldId="2147483653"/>
              <ac:spMk id="6" creationId="{0D5D0C75-724A-85B6-D857-2EF5BD03BF75}"/>
            </ac:spMkLst>
          </pc:spChg>
        </pc:sldLayoutChg>
        <pc:sldLayoutChg chg="modSp">
          <pc:chgData name="Riccardo Masina" userId="a1bc6b1a-f4be-41f4-bd72-f2c898d817ca" providerId="ADAL" clId="{C3FFD0B0-59D5-C845-A96A-72FFF02F2236}" dt="2022-11-21T10:57:05.238" v="23"/>
          <pc:sldLayoutMkLst>
            <pc:docMk/>
            <pc:sldMasterMk cId="543221463" sldId="2147483648"/>
            <pc:sldLayoutMk cId="1517264270" sldId="2147483656"/>
          </pc:sldLayoutMkLst>
          <pc:spChg chg="mod">
            <ac:chgData name="Riccardo Masina" userId="a1bc6b1a-f4be-41f4-bd72-f2c898d817ca" providerId="ADAL" clId="{C3FFD0B0-59D5-C845-A96A-72FFF02F2236}" dt="2022-11-21T10:57:05.238" v="23"/>
            <ac:spMkLst>
              <pc:docMk/>
              <pc:sldMasterMk cId="543221463" sldId="2147483648"/>
              <pc:sldLayoutMk cId="1517264270" sldId="2147483656"/>
              <ac:spMk id="2" creationId="{34696B3E-C878-5D6D-210B-F012ECDE5373}"/>
            </ac:spMkLst>
          </pc:spChg>
          <pc:spChg chg="mod">
            <ac:chgData name="Riccardo Masina" userId="a1bc6b1a-f4be-41f4-bd72-f2c898d817ca" providerId="ADAL" clId="{C3FFD0B0-59D5-C845-A96A-72FFF02F2236}" dt="2022-11-21T10:57:05.238" v="23"/>
            <ac:spMkLst>
              <pc:docMk/>
              <pc:sldMasterMk cId="543221463" sldId="2147483648"/>
              <pc:sldLayoutMk cId="1517264270" sldId="2147483656"/>
              <ac:spMk id="3" creationId="{424D25AA-DC03-7E3A-25FF-BBE0D45E5800}"/>
            </ac:spMkLst>
          </pc:spChg>
          <pc:spChg chg="mod">
            <ac:chgData name="Riccardo Masina" userId="a1bc6b1a-f4be-41f4-bd72-f2c898d817ca" providerId="ADAL" clId="{C3FFD0B0-59D5-C845-A96A-72FFF02F2236}" dt="2022-11-21T10:57:05.238" v="23"/>
            <ac:spMkLst>
              <pc:docMk/>
              <pc:sldMasterMk cId="543221463" sldId="2147483648"/>
              <pc:sldLayoutMk cId="1517264270" sldId="2147483656"/>
              <ac:spMk id="4" creationId="{83C1A367-C91E-8BB3-9F96-0091B0675DFD}"/>
            </ac:spMkLst>
          </pc:spChg>
        </pc:sldLayoutChg>
        <pc:sldLayoutChg chg="modSp">
          <pc:chgData name="Riccardo Masina" userId="a1bc6b1a-f4be-41f4-bd72-f2c898d817ca" providerId="ADAL" clId="{C3FFD0B0-59D5-C845-A96A-72FFF02F2236}" dt="2022-11-21T10:57:05.238" v="23"/>
          <pc:sldLayoutMkLst>
            <pc:docMk/>
            <pc:sldMasterMk cId="543221463" sldId="2147483648"/>
            <pc:sldLayoutMk cId="1742545708" sldId="2147483657"/>
          </pc:sldLayoutMkLst>
          <pc:spChg chg="mod">
            <ac:chgData name="Riccardo Masina" userId="a1bc6b1a-f4be-41f4-bd72-f2c898d817ca" providerId="ADAL" clId="{C3FFD0B0-59D5-C845-A96A-72FFF02F2236}" dt="2022-11-21T10:57:05.238" v="23"/>
            <ac:spMkLst>
              <pc:docMk/>
              <pc:sldMasterMk cId="543221463" sldId="2147483648"/>
              <pc:sldLayoutMk cId="1742545708" sldId="2147483657"/>
              <ac:spMk id="2" creationId="{EACE2CF7-A5E3-91B5-FB51-A1922EEB2A4B}"/>
            </ac:spMkLst>
          </pc:spChg>
          <pc:spChg chg="mod">
            <ac:chgData name="Riccardo Masina" userId="a1bc6b1a-f4be-41f4-bd72-f2c898d817ca" providerId="ADAL" clId="{C3FFD0B0-59D5-C845-A96A-72FFF02F2236}" dt="2022-11-21T10:57:05.238" v="23"/>
            <ac:spMkLst>
              <pc:docMk/>
              <pc:sldMasterMk cId="543221463" sldId="2147483648"/>
              <pc:sldLayoutMk cId="1742545708" sldId="2147483657"/>
              <ac:spMk id="3" creationId="{EF2D862A-E587-7B7C-861C-B5A7416B9A3B}"/>
            </ac:spMkLst>
          </pc:spChg>
          <pc:spChg chg="mod">
            <ac:chgData name="Riccardo Masina" userId="a1bc6b1a-f4be-41f4-bd72-f2c898d817ca" providerId="ADAL" clId="{C3FFD0B0-59D5-C845-A96A-72FFF02F2236}" dt="2022-11-21T10:57:05.238" v="23"/>
            <ac:spMkLst>
              <pc:docMk/>
              <pc:sldMasterMk cId="543221463" sldId="2147483648"/>
              <pc:sldLayoutMk cId="1742545708" sldId="2147483657"/>
              <ac:spMk id="4" creationId="{A953123C-F450-0062-2EDA-C7A016EE0EF0}"/>
            </ac:spMkLst>
          </pc:spChg>
        </pc:sldLayoutChg>
        <pc:sldLayoutChg chg="modSp">
          <pc:chgData name="Riccardo Masina" userId="a1bc6b1a-f4be-41f4-bd72-f2c898d817ca" providerId="ADAL" clId="{C3FFD0B0-59D5-C845-A96A-72FFF02F2236}" dt="2022-11-21T10:57:05.238" v="23"/>
          <pc:sldLayoutMkLst>
            <pc:docMk/>
            <pc:sldMasterMk cId="543221463" sldId="2147483648"/>
            <pc:sldLayoutMk cId="2969963944" sldId="2147483659"/>
          </pc:sldLayoutMkLst>
          <pc:spChg chg="mod">
            <ac:chgData name="Riccardo Masina" userId="a1bc6b1a-f4be-41f4-bd72-f2c898d817ca" providerId="ADAL" clId="{C3FFD0B0-59D5-C845-A96A-72FFF02F2236}" dt="2022-11-21T10:57:05.238" v="23"/>
            <ac:spMkLst>
              <pc:docMk/>
              <pc:sldMasterMk cId="543221463" sldId="2147483648"/>
              <pc:sldLayoutMk cId="2969963944" sldId="2147483659"/>
              <ac:spMk id="2" creationId="{3BB3D19C-8A1D-398D-1B3D-661D25AE4883}"/>
            </ac:spMkLst>
          </pc:spChg>
          <pc:spChg chg="mod">
            <ac:chgData name="Riccardo Masina" userId="a1bc6b1a-f4be-41f4-bd72-f2c898d817ca" providerId="ADAL" clId="{C3FFD0B0-59D5-C845-A96A-72FFF02F2236}" dt="2022-11-21T10:57:05.238" v="23"/>
            <ac:spMkLst>
              <pc:docMk/>
              <pc:sldMasterMk cId="543221463" sldId="2147483648"/>
              <pc:sldLayoutMk cId="2969963944" sldId="2147483659"/>
              <ac:spMk id="3" creationId="{BE0E036D-9C41-F495-31C1-E4FB095664EE}"/>
            </ac:spMkLst>
          </pc:spChg>
        </pc:sldLayoutChg>
      </pc:sldMasterChg>
    </pc:docChg>
  </pc:docChgLst>
  <pc:docChgLst>
    <pc:chgData name="Riccardo Masina" userId="a1bc6b1a-f4be-41f4-bd72-f2c898d817ca" providerId="ADAL" clId="{A8D950E3-911A-BA4B-922A-81307BFF7678}"/>
    <pc:docChg chg="custSel addSld delSld modSld">
      <pc:chgData name="Riccardo Masina" userId="a1bc6b1a-f4be-41f4-bd72-f2c898d817ca" providerId="ADAL" clId="{A8D950E3-911A-BA4B-922A-81307BFF7678}" dt="2022-06-20T17:06:38.370" v="151" actId="1076"/>
      <pc:docMkLst>
        <pc:docMk/>
      </pc:docMkLst>
      <pc:sldChg chg="del">
        <pc:chgData name="Riccardo Masina" userId="a1bc6b1a-f4be-41f4-bd72-f2c898d817ca" providerId="ADAL" clId="{A8D950E3-911A-BA4B-922A-81307BFF7678}" dt="2022-06-20T16:06:17.073" v="44" actId="2696"/>
        <pc:sldMkLst>
          <pc:docMk/>
          <pc:sldMk cId="1193990841" sldId="256"/>
        </pc:sldMkLst>
      </pc:sldChg>
      <pc:sldChg chg="addSp modSp mod modNotesTx">
        <pc:chgData name="Riccardo Masina" userId="a1bc6b1a-f4be-41f4-bd72-f2c898d817ca" providerId="ADAL" clId="{A8D950E3-911A-BA4B-922A-81307BFF7678}" dt="2022-06-20T17:04:18.409" v="60" actId="20577"/>
        <pc:sldMkLst>
          <pc:docMk/>
          <pc:sldMk cId="42739390" sldId="257"/>
        </pc:sldMkLst>
        <pc:spChg chg="add mod">
          <ac:chgData name="Riccardo Masina" userId="a1bc6b1a-f4be-41f4-bd72-f2c898d817ca" providerId="ADAL" clId="{A8D950E3-911A-BA4B-922A-81307BFF7678}" dt="2022-06-20T17:04:18.409" v="60" actId="20577"/>
          <ac:spMkLst>
            <pc:docMk/>
            <pc:sldMk cId="42739390" sldId="257"/>
            <ac:spMk id="2" creationId="{9E883060-081C-C344-3C1A-5526352A4CB0}"/>
          </ac:spMkLst>
        </pc:spChg>
        <pc:picChg chg="mod">
          <ac:chgData name="Riccardo Masina" userId="a1bc6b1a-f4be-41f4-bd72-f2c898d817ca" providerId="ADAL" clId="{A8D950E3-911A-BA4B-922A-81307BFF7678}" dt="2022-06-20T16:06:08.335" v="43" actId="1076"/>
          <ac:picMkLst>
            <pc:docMk/>
            <pc:sldMk cId="42739390" sldId="257"/>
            <ac:picMk id="5" creationId="{944A900D-B5D2-1421-8272-59DF02FCC3D1}"/>
          </ac:picMkLst>
        </pc:picChg>
      </pc:sldChg>
      <pc:sldChg chg="addSp modSp mod modNotesTx">
        <pc:chgData name="Riccardo Masina" userId="a1bc6b1a-f4be-41f4-bd72-f2c898d817ca" providerId="ADAL" clId="{A8D950E3-911A-BA4B-922A-81307BFF7678}" dt="2022-06-20T17:04:10.015" v="52" actId="20577"/>
        <pc:sldMkLst>
          <pc:docMk/>
          <pc:sldMk cId="4246051860" sldId="258"/>
        </pc:sldMkLst>
        <pc:spChg chg="add mod">
          <ac:chgData name="Riccardo Masina" userId="a1bc6b1a-f4be-41f4-bd72-f2c898d817ca" providerId="ADAL" clId="{A8D950E3-911A-BA4B-922A-81307BFF7678}" dt="2022-06-20T17:04:10.015" v="52" actId="20577"/>
          <ac:spMkLst>
            <pc:docMk/>
            <pc:sldMk cId="4246051860" sldId="258"/>
            <ac:spMk id="2" creationId="{334573E8-89EE-EF25-E8DC-AF87443CFF31}"/>
          </ac:spMkLst>
        </pc:spChg>
        <pc:picChg chg="mod">
          <ac:chgData name="Riccardo Masina" userId="a1bc6b1a-f4be-41f4-bd72-f2c898d817ca" providerId="ADAL" clId="{A8D950E3-911A-BA4B-922A-81307BFF7678}" dt="2022-06-20T16:07:12.195" v="46" actId="1076"/>
          <ac:picMkLst>
            <pc:docMk/>
            <pc:sldMk cId="4246051860" sldId="258"/>
            <ac:picMk id="5" creationId="{C979FEE9-2FE3-5FFE-D93B-66EC70E7EDAE}"/>
          </ac:picMkLst>
        </pc:picChg>
      </pc:sldChg>
      <pc:sldChg chg="addSp modSp mod">
        <pc:chgData name="Riccardo Masina" userId="a1bc6b1a-f4be-41f4-bd72-f2c898d817ca" providerId="ADAL" clId="{A8D950E3-911A-BA4B-922A-81307BFF7678}" dt="2022-06-20T17:04:04.195" v="50" actId="20577"/>
        <pc:sldMkLst>
          <pc:docMk/>
          <pc:sldMk cId="1642274118" sldId="259"/>
        </pc:sldMkLst>
        <pc:spChg chg="add mod">
          <ac:chgData name="Riccardo Masina" userId="a1bc6b1a-f4be-41f4-bd72-f2c898d817ca" providerId="ADAL" clId="{A8D950E3-911A-BA4B-922A-81307BFF7678}" dt="2022-06-20T17:04:04.195" v="50" actId="20577"/>
          <ac:spMkLst>
            <pc:docMk/>
            <pc:sldMk cId="1642274118" sldId="259"/>
            <ac:spMk id="2" creationId="{0F85A424-A4A1-8753-AE19-16487562B8B2}"/>
          </ac:spMkLst>
        </pc:spChg>
        <pc:picChg chg="mod">
          <ac:chgData name="Riccardo Masina" userId="a1bc6b1a-f4be-41f4-bd72-f2c898d817ca" providerId="ADAL" clId="{A8D950E3-911A-BA4B-922A-81307BFF7678}" dt="2022-06-20T16:07:18.644" v="48" actId="1076"/>
          <ac:picMkLst>
            <pc:docMk/>
            <pc:sldMk cId="1642274118" sldId="259"/>
            <ac:picMk id="5" creationId="{AF2D1A8A-96A8-B86A-E3A1-49781370E420}"/>
          </ac:picMkLst>
        </pc:picChg>
      </pc:sldChg>
      <pc:sldChg chg="addSp delSp modSp new mod">
        <pc:chgData name="Riccardo Masina" userId="a1bc6b1a-f4be-41f4-bd72-f2c898d817ca" providerId="ADAL" clId="{A8D950E3-911A-BA4B-922A-81307BFF7678}" dt="2022-06-20T17:06:38.370" v="151" actId="1076"/>
        <pc:sldMkLst>
          <pc:docMk/>
          <pc:sldMk cId="3693887694" sldId="260"/>
        </pc:sldMkLst>
        <pc:spChg chg="del">
          <ac:chgData name="Riccardo Masina" userId="a1bc6b1a-f4be-41f4-bd72-f2c898d817ca" providerId="ADAL" clId="{A8D950E3-911A-BA4B-922A-81307BFF7678}" dt="2022-06-20T17:04:22.827" v="62" actId="478"/>
          <ac:spMkLst>
            <pc:docMk/>
            <pc:sldMk cId="3693887694" sldId="260"/>
            <ac:spMk id="2" creationId="{3C2099A3-54F0-6B82-12AC-8832846C0CBD}"/>
          </ac:spMkLst>
        </pc:spChg>
        <pc:spChg chg="del">
          <ac:chgData name="Riccardo Masina" userId="a1bc6b1a-f4be-41f4-bd72-f2c898d817ca" providerId="ADAL" clId="{A8D950E3-911A-BA4B-922A-81307BFF7678}" dt="2022-06-20T17:04:24.891" v="63" actId="478"/>
          <ac:spMkLst>
            <pc:docMk/>
            <pc:sldMk cId="3693887694" sldId="260"/>
            <ac:spMk id="3" creationId="{BA99A50D-F21A-9DA5-72C0-279BECA9F2FE}"/>
          </ac:spMkLst>
        </pc:spChg>
        <pc:spChg chg="add mod">
          <ac:chgData name="Riccardo Masina" userId="a1bc6b1a-f4be-41f4-bd72-f2c898d817ca" providerId="ADAL" clId="{A8D950E3-911A-BA4B-922A-81307BFF7678}" dt="2022-06-20T17:06:38.370" v="151" actId="1076"/>
          <ac:spMkLst>
            <pc:docMk/>
            <pc:sldMk cId="3693887694" sldId="260"/>
            <ac:spMk id="6" creationId="{19513A57-B7A8-09DB-2AAE-5AFDE2ABA4F0}"/>
          </ac:spMkLst>
        </pc:spChg>
        <pc:picChg chg="add mod modCrop">
          <ac:chgData name="Riccardo Masina" userId="a1bc6b1a-f4be-41f4-bd72-f2c898d817ca" providerId="ADAL" clId="{A8D950E3-911A-BA4B-922A-81307BFF7678}" dt="2022-06-20T17:06:24.502" v="147" actId="732"/>
          <ac:picMkLst>
            <pc:docMk/>
            <pc:sldMk cId="3693887694" sldId="260"/>
            <ac:picMk id="5" creationId="{47E3D17B-8802-7A3E-AD9B-EFE128C80F78}"/>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C5FC2E7-D95E-CC47-976B-0BDC9A50270E}" type="datetimeFigureOut">
              <a:rPr lang="en-US" smtClean="0"/>
              <a:t>1/31/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405BDD-7231-CD41-8BA9-599E0A00D013}" type="slidenum">
              <a:rPr lang="en-US" smtClean="0"/>
              <a:t>‹#›</a:t>
            </a:fld>
            <a:endParaRPr lang="en-US"/>
          </a:p>
        </p:txBody>
      </p:sp>
    </p:spTree>
    <p:extLst>
      <p:ext uri="{BB962C8B-B14F-4D97-AF65-F5344CB8AC3E}">
        <p14:creationId xmlns:p14="http://schemas.microsoft.com/office/powerpoint/2010/main" val="17836548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a:t>Supplementary Figure 1:</a:t>
            </a:r>
          </a:p>
          <a:p>
            <a:r>
              <a:rPr lang="en-US" dirty="0"/>
              <a:t>Scatterplots for visual assessment of the association between covariates (by column) and cognitive deficit (by row) at T1</a:t>
            </a:r>
          </a:p>
        </p:txBody>
      </p:sp>
      <p:sp>
        <p:nvSpPr>
          <p:cNvPr id="4" name="Slide Number Placeholder 3"/>
          <p:cNvSpPr>
            <a:spLocks noGrp="1"/>
          </p:cNvSpPr>
          <p:nvPr>
            <p:ph type="sldNum" sz="quarter" idx="5"/>
          </p:nvPr>
        </p:nvSpPr>
        <p:spPr/>
        <p:txBody>
          <a:bodyPr/>
          <a:lstStyle/>
          <a:p>
            <a:fld id="{A6405BDD-7231-CD41-8BA9-599E0A00D013}" type="slidenum">
              <a:rPr lang="en-US" smtClean="0"/>
              <a:t>2</a:t>
            </a:fld>
            <a:endParaRPr lang="en-US"/>
          </a:p>
        </p:txBody>
      </p:sp>
    </p:spTree>
    <p:extLst>
      <p:ext uri="{BB962C8B-B14F-4D97-AF65-F5344CB8AC3E}">
        <p14:creationId xmlns:p14="http://schemas.microsoft.com/office/powerpoint/2010/main" val="23815645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a:t>Supplementary Figure 2:</a:t>
            </a:r>
          </a:p>
          <a:p>
            <a:r>
              <a:rPr lang="en-US" dirty="0"/>
              <a:t>Scatterplots for visual assessment of the association between covariates (by column) and cognitive deficit (by row) at T2</a:t>
            </a:r>
          </a:p>
          <a:p>
            <a:endParaRPr lang="en-US" dirty="0"/>
          </a:p>
        </p:txBody>
      </p:sp>
      <p:sp>
        <p:nvSpPr>
          <p:cNvPr id="4" name="Slide Number Placeholder 3"/>
          <p:cNvSpPr>
            <a:spLocks noGrp="1"/>
          </p:cNvSpPr>
          <p:nvPr>
            <p:ph type="sldNum" sz="quarter" idx="5"/>
          </p:nvPr>
        </p:nvSpPr>
        <p:spPr/>
        <p:txBody>
          <a:bodyPr/>
          <a:lstStyle/>
          <a:p>
            <a:fld id="{A6405BDD-7231-CD41-8BA9-599E0A00D013}" type="slidenum">
              <a:rPr lang="en-US" smtClean="0"/>
              <a:t>3</a:t>
            </a:fld>
            <a:endParaRPr lang="en-US"/>
          </a:p>
        </p:txBody>
      </p:sp>
    </p:spTree>
    <p:extLst>
      <p:ext uri="{BB962C8B-B14F-4D97-AF65-F5344CB8AC3E}">
        <p14:creationId xmlns:p14="http://schemas.microsoft.com/office/powerpoint/2010/main" val="231550178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a:t>Supplementary Figure 3:</a:t>
            </a:r>
          </a:p>
          <a:p>
            <a:endParaRPr lang="en-US" dirty="0"/>
          </a:p>
          <a:p>
            <a:r>
              <a:rPr lang="en-US" dirty="0"/>
              <a:t>Scatterplots for visual assessment of the association between covariates (by column) and change in cognitive deficit status (by row) at T1T2</a:t>
            </a:r>
          </a:p>
          <a:p>
            <a:endParaRPr lang="en-US" dirty="0"/>
          </a:p>
        </p:txBody>
      </p:sp>
      <p:sp>
        <p:nvSpPr>
          <p:cNvPr id="4" name="Slide Number Placeholder 3"/>
          <p:cNvSpPr>
            <a:spLocks noGrp="1"/>
          </p:cNvSpPr>
          <p:nvPr>
            <p:ph type="sldNum" sz="quarter" idx="5"/>
          </p:nvPr>
        </p:nvSpPr>
        <p:spPr/>
        <p:txBody>
          <a:bodyPr/>
          <a:lstStyle/>
          <a:p>
            <a:fld id="{A6405BDD-7231-CD41-8BA9-599E0A00D013}" type="slidenum">
              <a:rPr lang="en-US" smtClean="0"/>
              <a:t>4</a:t>
            </a:fld>
            <a:endParaRPr lang="en-US"/>
          </a:p>
        </p:txBody>
      </p:sp>
    </p:spTree>
    <p:extLst>
      <p:ext uri="{BB962C8B-B14F-4D97-AF65-F5344CB8AC3E}">
        <p14:creationId xmlns:p14="http://schemas.microsoft.com/office/powerpoint/2010/main" val="13308985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1832E5-A74C-E42F-8E98-1C5BE9D3D761}"/>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123E35CC-00FA-EE45-31DA-ACBE0CE334D0}"/>
              </a:ext>
            </a:extLst>
          </p:cNvPr>
          <p:cNvSpPr>
            <a:spLocks noGrp="1"/>
          </p:cNvSpPr>
          <p:nvPr>
            <p:ph type="subTitle" idx="1"/>
          </p:nvPr>
        </p:nvSpPr>
        <p:spPr>
          <a:xfrm>
            <a:off x="1524000" y="3602039"/>
            <a:ext cx="9144000" cy="1655762"/>
          </a:xfrm>
        </p:spPr>
        <p:txBody>
          <a:bodyPr/>
          <a:lstStyle>
            <a:lvl1pPr marL="0" indent="0" algn="ctr">
              <a:buNone/>
              <a:defRPr sz="2400"/>
            </a:lvl1pPr>
            <a:lvl2pPr marL="457189" indent="0" algn="ctr">
              <a:buNone/>
              <a:defRPr sz="2000"/>
            </a:lvl2pPr>
            <a:lvl3pPr marL="914378" indent="0" algn="ctr">
              <a:buNone/>
              <a:defRPr sz="1800"/>
            </a:lvl3pPr>
            <a:lvl4pPr marL="1371567" indent="0" algn="ctr">
              <a:buNone/>
              <a:defRPr sz="1600"/>
            </a:lvl4pPr>
            <a:lvl5pPr marL="1828755" indent="0" algn="ctr">
              <a:buNone/>
              <a:defRPr sz="1600"/>
            </a:lvl5pPr>
            <a:lvl6pPr marL="2285944" indent="0" algn="ctr">
              <a:buNone/>
              <a:defRPr sz="1600"/>
            </a:lvl6pPr>
            <a:lvl7pPr marL="2743134" indent="0" algn="ctr">
              <a:buNone/>
              <a:defRPr sz="1600"/>
            </a:lvl7pPr>
            <a:lvl8pPr marL="3200322" indent="0" algn="ctr">
              <a:buNone/>
              <a:defRPr sz="1600"/>
            </a:lvl8pPr>
            <a:lvl9pPr marL="3657511"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BD0DCA48-8A05-E673-410D-7D9C100598C4}"/>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5" name="Footer Placeholder 4">
            <a:extLst>
              <a:ext uri="{FF2B5EF4-FFF2-40B4-BE49-F238E27FC236}">
                <a16:creationId xmlns:a16="http://schemas.microsoft.com/office/drawing/2014/main" id="{9AB4DCCE-121B-6CA5-3E7F-7652C6350BA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6BAD44C-7CD4-2744-D470-56A3CB88D592}"/>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34229185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D59839-768C-389D-4C4A-2A1B4BD9228D}"/>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0A6A59D2-F7BE-4A63-64B4-0270E16F1AA8}"/>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5471CBA3-ED78-BDF7-6DDE-0BF1C952F1C1}"/>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5" name="Footer Placeholder 4">
            <a:extLst>
              <a:ext uri="{FF2B5EF4-FFF2-40B4-BE49-F238E27FC236}">
                <a16:creationId xmlns:a16="http://schemas.microsoft.com/office/drawing/2014/main" id="{B0010A15-7D86-BEA2-FCE1-06950405DD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91D9C8D-F59A-CF21-8A66-D7811F3D1105}"/>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18794624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BB3D19C-8A1D-398D-1B3D-661D25AE4883}"/>
              </a:ext>
            </a:extLst>
          </p:cNvPr>
          <p:cNvSpPr>
            <a:spLocks noGrp="1"/>
          </p:cNvSpPr>
          <p:nvPr>
            <p:ph type="title" orient="vert"/>
          </p:nvPr>
        </p:nvSpPr>
        <p:spPr>
          <a:xfrm>
            <a:off x="8724899"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BE0E036D-9C41-F495-31C1-E4FB095664EE}"/>
              </a:ext>
            </a:extLst>
          </p:cNvPr>
          <p:cNvSpPr>
            <a:spLocks noGrp="1"/>
          </p:cNvSpPr>
          <p:nvPr>
            <p:ph type="body" orient="vert" idx="1"/>
          </p:nvPr>
        </p:nvSpPr>
        <p:spPr>
          <a:xfrm>
            <a:off x="838199"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12021491-26E1-864C-D386-2FD0310924FA}"/>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5" name="Footer Placeholder 4">
            <a:extLst>
              <a:ext uri="{FF2B5EF4-FFF2-40B4-BE49-F238E27FC236}">
                <a16:creationId xmlns:a16="http://schemas.microsoft.com/office/drawing/2014/main" id="{A6A25247-B10E-501B-F636-7843F76B94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B42FBE3-B2BB-B2B7-6036-121129E53994}"/>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29699639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7739F4-1573-F31F-34A9-7BA519869FE5}"/>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89E5F095-8436-3601-1091-AEDE7EF7F5A8}"/>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33A03E9-827A-62BE-E3BC-581A491DBC38}"/>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5" name="Footer Placeholder 4">
            <a:extLst>
              <a:ext uri="{FF2B5EF4-FFF2-40B4-BE49-F238E27FC236}">
                <a16:creationId xmlns:a16="http://schemas.microsoft.com/office/drawing/2014/main" id="{E00B86D3-833D-C535-BAD3-1CFD62BC61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765BE76-F891-074F-D4ED-82E32B31442B}"/>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38115881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11468B-489F-D176-42BC-F8D7762FB80D}"/>
              </a:ext>
            </a:extLst>
          </p:cNvPr>
          <p:cNvSpPr>
            <a:spLocks noGrp="1"/>
          </p:cNvSpPr>
          <p:nvPr>
            <p:ph type="title"/>
          </p:nvPr>
        </p:nvSpPr>
        <p:spPr>
          <a:xfrm>
            <a:off x="831852" y="1709739"/>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8590627C-D0A4-E821-57EA-4BE598D35C3D}"/>
              </a:ext>
            </a:extLst>
          </p:cNvPr>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8" indent="0">
              <a:buNone/>
              <a:defRPr sz="1800">
                <a:solidFill>
                  <a:schemeClr val="tx1">
                    <a:tint val="75000"/>
                  </a:schemeClr>
                </a:solidFill>
              </a:defRPr>
            </a:lvl3pPr>
            <a:lvl4pPr marL="1371567" indent="0">
              <a:buNone/>
              <a:defRPr sz="1600">
                <a:solidFill>
                  <a:schemeClr val="tx1">
                    <a:tint val="75000"/>
                  </a:schemeClr>
                </a:solidFill>
              </a:defRPr>
            </a:lvl4pPr>
            <a:lvl5pPr marL="1828755" indent="0">
              <a:buNone/>
              <a:defRPr sz="1600">
                <a:solidFill>
                  <a:schemeClr val="tx1">
                    <a:tint val="75000"/>
                  </a:schemeClr>
                </a:solidFill>
              </a:defRPr>
            </a:lvl5pPr>
            <a:lvl6pPr marL="2285944" indent="0">
              <a:buNone/>
              <a:defRPr sz="1600">
                <a:solidFill>
                  <a:schemeClr val="tx1">
                    <a:tint val="75000"/>
                  </a:schemeClr>
                </a:solidFill>
              </a:defRPr>
            </a:lvl6pPr>
            <a:lvl7pPr marL="2743134" indent="0">
              <a:buNone/>
              <a:defRPr sz="1600">
                <a:solidFill>
                  <a:schemeClr val="tx1">
                    <a:tint val="75000"/>
                  </a:schemeClr>
                </a:solidFill>
              </a:defRPr>
            </a:lvl7pPr>
            <a:lvl8pPr marL="3200322" indent="0">
              <a:buNone/>
              <a:defRPr sz="1600">
                <a:solidFill>
                  <a:schemeClr val="tx1">
                    <a:tint val="75000"/>
                  </a:schemeClr>
                </a:solidFill>
              </a:defRPr>
            </a:lvl8pPr>
            <a:lvl9pPr marL="3657511"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38D14835-107B-8DA9-96A5-CE14FC6BD787}"/>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5" name="Footer Placeholder 4">
            <a:extLst>
              <a:ext uri="{FF2B5EF4-FFF2-40B4-BE49-F238E27FC236}">
                <a16:creationId xmlns:a16="http://schemas.microsoft.com/office/drawing/2014/main" id="{5E8E2004-E498-F6DC-04FC-274D7CF3A2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A02227-821A-03E7-3F82-0A5DB00B5738}"/>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18489855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B0AD5D-D439-5BAB-0237-C23034F0839F}"/>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02CAC68B-8534-BFD1-D089-F10A3E0E5CCC}"/>
              </a:ext>
            </a:extLst>
          </p:cNvPr>
          <p:cNvSpPr>
            <a:spLocks noGrp="1"/>
          </p:cNvSpPr>
          <p:nvPr>
            <p:ph sz="half" idx="1"/>
          </p:nvPr>
        </p:nvSpPr>
        <p:spPr>
          <a:xfrm>
            <a:off x="838201"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E9E70DDE-0727-87FE-DD1B-2C67E08D538B}"/>
              </a:ext>
            </a:extLst>
          </p:cNvPr>
          <p:cNvSpPr>
            <a:spLocks noGrp="1"/>
          </p:cNvSpPr>
          <p:nvPr>
            <p:ph sz="half" idx="2"/>
          </p:nvPr>
        </p:nvSpPr>
        <p:spPr>
          <a:xfrm>
            <a:off x="6172201"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8FDB8C98-5050-8B0B-B3BE-E625D13C2089}"/>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6" name="Footer Placeholder 5">
            <a:extLst>
              <a:ext uri="{FF2B5EF4-FFF2-40B4-BE49-F238E27FC236}">
                <a16:creationId xmlns:a16="http://schemas.microsoft.com/office/drawing/2014/main" id="{D58F98A3-6145-5BAB-8FAF-B89953764C3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BC5A879-B728-9BD6-F15E-B5504C20123C}"/>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15140862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1A8887-5598-3FB8-1326-917EFDAD40C3}"/>
              </a:ext>
            </a:extLst>
          </p:cNvPr>
          <p:cNvSpPr>
            <a:spLocks noGrp="1"/>
          </p:cNvSpPr>
          <p:nvPr>
            <p:ph type="title"/>
          </p:nvPr>
        </p:nvSpPr>
        <p:spPr>
          <a:xfrm>
            <a:off x="839789"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2236D473-A511-B62F-1DDF-368385664956}"/>
              </a:ext>
            </a:extLst>
          </p:cNvPr>
          <p:cNvSpPr>
            <a:spLocks noGrp="1"/>
          </p:cNvSpPr>
          <p:nvPr>
            <p:ph type="body" idx="1"/>
          </p:nvPr>
        </p:nvSpPr>
        <p:spPr>
          <a:xfrm>
            <a:off x="839789" y="1681163"/>
            <a:ext cx="5157787" cy="823912"/>
          </a:xfrm>
        </p:spPr>
        <p:txBody>
          <a:bodyPr anchor="b"/>
          <a:lstStyle>
            <a:lvl1pPr marL="0" indent="0">
              <a:buNone/>
              <a:defRPr sz="2400" b="1"/>
            </a:lvl1pPr>
            <a:lvl2pPr marL="457189" indent="0">
              <a:buNone/>
              <a:defRPr sz="2000" b="1"/>
            </a:lvl2pPr>
            <a:lvl3pPr marL="914378" indent="0">
              <a:buNone/>
              <a:defRPr sz="1800" b="1"/>
            </a:lvl3pPr>
            <a:lvl4pPr marL="1371567" indent="0">
              <a:buNone/>
              <a:defRPr sz="1600" b="1"/>
            </a:lvl4pPr>
            <a:lvl5pPr marL="1828755" indent="0">
              <a:buNone/>
              <a:defRPr sz="1600" b="1"/>
            </a:lvl5pPr>
            <a:lvl6pPr marL="2285944" indent="0">
              <a:buNone/>
              <a:defRPr sz="1600" b="1"/>
            </a:lvl6pPr>
            <a:lvl7pPr marL="2743134" indent="0">
              <a:buNone/>
              <a:defRPr sz="1600" b="1"/>
            </a:lvl7pPr>
            <a:lvl8pPr marL="3200322" indent="0">
              <a:buNone/>
              <a:defRPr sz="1600" b="1"/>
            </a:lvl8pPr>
            <a:lvl9pPr marL="3657511"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FF9F36D6-9DBB-5608-6E65-29EAA77DED7E}"/>
              </a:ext>
            </a:extLst>
          </p:cNvPr>
          <p:cNvSpPr>
            <a:spLocks noGrp="1"/>
          </p:cNvSpPr>
          <p:nvPr>
            <p:ph sz="half" idx="2"/>
          </p:nvPr>
        </p:nvSpPr>
        <p:spPr>
          <a:xfrm>
            <a:off x="839789"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353F4A0A-A2BC-BACE-875C-AF013F318C86}"/>
              </a:ext>
            </a:extLst>
          </p:cNvPr>
          <p:cNvSpPr>
            <a:spLocks noGrp="1"/>
          </p:cNvSpPr>
          <p:nvPr>
            <p:ph type="body" sz="quarter" idx="3"/>
          </p:nvPr>
        </p:nvSpPr>
        <p:spPr>
          <a:xfrm>
            <a:off x="6172202" y="1681163"/>
            <a:ext cx="5183188" cy="823912"/>
          </a:xfrm>
        </p:spPr>
        <p:txBody>
          <a:bodyPr anchor="b"/>
          <a:lstStyle>
            <a:lvl1pPr marL="0" indent="0">
              <a:buNone/>
              <a:defRPr sz="2400" b="1"/>
            </a:lvl1pPr>
            <a:lvl2pPr marL="457189" indent="0">
              <a:buNone/>
              <a:defRPr sz="2000" b="1"/>
            </a:lvl2pPr>
            <a:lvl3pPr marL="914378" indent="0">
              <a:buNone/>
              <a:defRPr sz="1800" b="1"/>
            </a:lvl3pPr>
            <a:lvl4pPr marL="1371567" indent="0">
              <a:buNone/>
              <a:defRPr sz="1600" b="1"/>
            </a:lvl4pPr>
            <a:lvl5pPr marL="1828755" indent="0">
              <a:buNone/>
              <a:defRPr sz="1600" b="1"/>
            </a:lvl5pPr>
            <a:lvl6pPr marL="2285944" indent="0">
              <a:buNone/>
              <a:defRPr sz="1600" b="1"/>
            </a:lvl6pPr>
            <a:lvl7pPr marL="2743134" indent="0">
              <a:buNone/>
              <a:defRPr sz="1600" b="1"/>
            </a:lvl7pPr>
            <a:lvl8pPr marL="3200322" indent="0">
              <a:buNone/>
              <a:defRPr sz="1600" b="1"/>
            </a:lvl8pPr>
            <a:lvl9pPr marL="3657511"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0D5D0C75-724A-85B6-D857-2EF5BD03BF75}"/>
              </a:ext>
            </a:extLst>
          </p:cNvPr>
          <p:cNvSpPr>
            <a:spLocks noGrp="1"/>
          </p:cNvSpPr>
          <p:nvPr>
            <p:ph sz="quarter" idx="4"/>
          </p:nvPr>
        </p:nvSpPr>
        <p:spPr>
          <a:xfrm>
            <a:off x="6172202"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F59B32F0-42C2-AB02-A82C-9CB3AF31BE4F}"/>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8" name="Footer Placeholder 7">
            <a:extLst>
              <a:ext uri="{FF2B5EF4-FFF2-40B4-BE49-F238E27FC236}">
                <a16:creationId xmlns:a16="http://schemas.microsoft.com/office/drawing/2014/main" id="{90482114-B679-4C24-40BD-2189508484D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79AB92C-31A4-0517-FF92-591118BFB6EC}"/>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924526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2ED442-617C-7F44-5ECB-A75A6EA25159}"/>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ECE7405C-9745-709F-EF24-56BE5135C7D9}"/>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4" name="Footer Placeholder 3">
            <a:extLst>
              <a:ext uri="{FF2B5EF4-FFF2-40B4-BE49-F238E27FC236}">
                <a16:creationId xmlns:a16="http://schemas.microsoft.com/office/drawing/2014/main" id="{2D705C64-D29C-9338-EC27-817F2440161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DAE2DE-49D8-D012-5491-160F33FD4094}"/>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15736340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8C32320-7C63-ADC2-9A9C-8B7460D730DD}"/>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3" name="Footer Placeholder 2">
            <a:extLst>
              <a:ext uri="{FF2B5EF4-FFF2-40B4-BE49-F238E27FC236}">
                <a16:creationId xmlns:a16="http://schemas.microsoft.com/office/drawing/2014/main" id="{07F8F85F-01F7-BC23-45B0-B7C3CD9470A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C797BEC-5265-6BDE-ECF7-B9546BB0436A}"/>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38143140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696B3E-C878-5D6D-210B-F012ECDE5373}"/>
              </a:ext>
            </a:extLst>
          </p:cNvPr>
          <p:cNvSpPr>
            <a:spLocks noGrp="1"/>
          </p:cNvSpPr>
          <p:nvPr>
            <p:ph type="title"/>
          </p:nvPr>
        </p:nvSpPr>
        <p:spPr>
          <a:xfrm>
            <a:off x="839790" y="457201"/>
            <a:ext cx="3932236"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424D25AA-DC03-7E3A-25FF-BBE0D45E5800}"/>
              </a:ext>
            </a:extLst>
          </p:cNvPr>
          <p:cNvSpPr>
            <a:spLocks noGrp="1"/>
          </p:cNvSpPr>
          <p:nvPr>
            <p:ph idx="1"/>
          </p:nvPr>
        </p:nvSpPr>
        <p:spPr>
          <a:xfrm>
            <a:off x="5183188" y="987426"/>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83C1A367-C91E-8BB3-9F96-0091B0675DFD}"/>
              </a:ext>
            </a:extLst>
          </p:cNvPr>
          <p:cNvSpPr>
            <a:spLocks noGrp="1"/>
          </p:cNvSpPr>
          <p:nvPr>
            <p:ph type="body" sz="half" idx="2"/>
          </p:nvPr>
        </p:nvSpPr>
        <p:spPr>
          <a:xfrm>
            <a:off x="839790" y="2057400"/>
            <a:ext cx="3932236" cy="3811588"/>
          </a:xfrm>
        </p:spPr>
        <p:txBody>
          <a:bodyPr/>
          <a:lstStyle>
            <a:lvl1pPr marL="0" indent="0">
              <a:buNone/>
              <a:defRPr sz="1600"/>
            </a:lvl1pPr>
            <a:lvl2pPr marL="457189" indent="0">
              <a:buNone/>
              <a:defRPr sz="1400"/>
            </a:lvl2pPr>
            <a:lvl3pPr marL="914378" indent="0">
              <a:buNone/>
              <a:defRPr sz="1200"/>
            </a:lvl3pPr>
            <a:lvl4pPr marL="1371567" indent="0">
              <a:buNone/>
              <a:defRPr sz="1000"/>
            </a:lvl4pPr>
            <a:lvl5pPr marL="1828755" indent="0">
              <a:buNone/>
              <a:defRPr sz="1000"/>
            </a:lvl5pPr>
            <a:lvl6pPr marL="2285944" indent="0">
              <a:buNone/>
              <a:defRPr sz="1000"/>
            </a:lvl6pPr>
            <a:lvl7pPr marL="2743134" indent="0">
              <a:buNone/>
              <a:defRPr sz="1000"/>
            </a:lvl7pPr>
            <a:lvl8pPr marL="3200322" indent="0">
              <a:buNone/>
              <a:defRPr sz="1000"/>
            </a:lvl8pPr>
            <a:lvl9pPr marL="3657511"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27551C21-7A8D-4865-4CA7-442AE041B2F4}"/>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6" name="Footer Placeholder 5">
            <a:extLst>
              <a:ext uri="{FF2B5EF4-FFF2-40B4-BE49-F238E27FC236}">
                <a16:creationId xmlns:a16="http://schemas.microsoft.com/office/drawing/2014/main" id="{12755CAC-DB69-C4BE-9A81-0C373D9B550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82D95C8-78FA-5C87-CB9E-EA680AB0F26B}"/>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15172642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CE2CF7-A5E3-91B5-FB51-A1922EEB2A4B}"/>
              </a:ext>
            </a:extLst>
          </p:cNvPr>
          <p:cNvSpPr>
            <a:spLocks noGrp="1"/>
          </p:cNvSpPr>
          <p:nvPr>
            <p:ph type="title"/>
          </p:nvPr>
        </p:nvSpPr>
        <p:spPr>
          <a:xfrm>
            <a:off x="839790" y="457201"/>
            <a:ext cx="3932236"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EF2D862A-E587-7B7C-861C-B5A7416B9A3B}"/>
              </a:ext>
            </a:extLst>
          </p:cNvPr>
          <p:cNvSpPr>
            <a:spLocks noGrp="1"/>
          </p:cNvSpPr>
          <p:nvPr>
            <p:ph type="pic" idx="1"/>
          </p:nvPr>
        </p:nvSpPr>
        <p:spPr>
          <a:xfrm>
            <a:off x="5183188" y="987426"/>
            <a:ext cx="6172201" cy="4873625"/>
          </a:xfrm>
        </p:spPr>
        <p:txBody>
          <a:bodyPr/>
          <a:lstStyle>
            <a:lvl1pPr marL="0" indent="0">
              <a:buNone/>
              <a:defRPr sz="3200"/>
            </a:lvl1pPr>
            <a:lvl2pPr marL="457189" indent="0">
              <a:buNone/>
              <a:defRPr sz="2800"/>
            </a:lvl2pPr>
            <a:lvl3pPr marL="914378" indent="0">
              <a:buNone/>
              <a:defRPr sz="2400"/>
            </a:lvl3pPr>
            <a:lvl4pPr marL="1371567" indent="0">
              <a:buNone/>
              <a:defRPr sz="2000"/>
            </a:lvl4pPr>
            <a:lvl5pPr marL="1828755" indent="0">
              <a:buNone/>
              <a:defRPr sz="2000"/>
            </a:lvl5pPr>
            <a:lvl6pPr marL="2285944" indent="0">
              <a:buNone/>
              <a:defRPr sz="2000"/>
            </a:lvl6pPr>
            <a:lvl7pPr marL="2743134" indent="0">
              <a:buNone/>
              <a:defRPr sz="2000"/>
            </a:lvl7pPr>
            <a:lvl8pPr marL="3200322" indent="0">
              <a:buNone/>
              <a:defRPr sz="2000"/>
            </a:lvl8pPr>
            <a:lvl9pPr marL="3657511" indent="0">
              <a:buNone/>
              <a:defRPr sz="2000"/>
            </a:lvl9pPr>
          </a:lstStyle>
          <a:p>
            <a:endParaRPr lang="en-US"/>
          </a:p>
        </p:txBody>
      </p:sp>
      <p:sp>
        <p:nvSpPr>
          <p:cNvPr id="4" name="Text Placeholder 3">
            <a:extLst>
              <a:ext uri="{FF2B5EF4-FFF2-40B4-BE49-F238E27FC236}">
                <a16:creationId xmlns:a16="http://schemas.microsoft.com/office/drawing/2014/main" id="{A953123C-F450-0062-2EDA-C7A016EE0EF0}"/>
              </a:ext>
            </a:extLst>
          </p:cNvPr>
          <p:cNvSpPr>
            <a:spLocks noGrp="1"/>
          </p:cNvSpPr>
          <p:nvPr>
            <p:ph type="body" sz="half" idx="2"/>
          </p:nvPr>
        </p:nvSpPr>
        <p:spPr>
          <a:xfrm>
            <a:off x="839790" y="2057400"/>
            <a:ext cx="3932236" cy="3811588"/>
          </a:xfrm>
        </p:spPr>
        <p:txBody>
          <a:bodyPr/>
          <a:lstStyle>
            <a:lvl1pPr marL="0" indent="0">
              <a:buNone/>
              <a:defRPr sz="1600"/>
            </a:lvl1pPr>
            <a:lvl2pPr marL="457189" indent="0">
              <a:buNone/>
              <a:defRPr sz="1400"/>
            </a:lvl2pPr>
            <a:lvl3pPr marL="914378" indent="0">
              <a:buNone/>
              <a:defRPr sz="1200"/>
            </a:lvl3pPr>
            <a:lvl4pPr marL="1371567" indent="0">
              <a:buNone/>
              <a:defRPr sz="1000"/>
            </a:lvl4pPr>
            <a:lvl5pPr marL="1828755" indent="0">
              <a:buNone/>
              <a:defRPr sz="1000"/>
            </a:lvl5pPr>
            <a:lvl6pPr marL="2285944" indent="0">
              <a:buNone/>
              <a:defRPr sz="1000"/>
            </a:lvl6pPr>
            <a:lvl7pPr marL="2743134" indent="0">
              <a:buNone/>
              <a:defRPr sz="1000"/>
            </a:lvl7pPr>
            <a:lvl8pPr marL="3200322" indent="0">
              <a:buNone/>
              <a:defRPr sz="1000"/>
            </a:lvl8pPr>
            <a:lvl9pPr marL="3657511"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DD74A988-0782-F020-989D-F4A5D15E85EB}"/>
              </a:ext>
            </a:extLst>
          </p:cNvPr>
          <p:cNvSpPr>
            <a:spLocks noGrp="1"/>
          </p:cNvSpPr>
          <p:nvPr>
            <p:ph type="dt" sz="half" idx="10"/>
          </p:nvPr>
        </p:nvSpPr>
        <p:spPr/>
        <p:txBody>
          <a:bodyPr/>
          <a:lstStyle/>
          <a:p>
            <a:fld id="{6BEFAE93-C21E-1948-8FF6-085838AAC2D7}" type="datetimeFigureOut">
              <a:rPr lang="en-US" smtClean="0"/>
              <a:t>1/31/2023</a:t>
            </a:fld>
            <a:endParaRPr lang="en-US"/>
          </a:p>
        </p:txBody>
      </p:sp>
      <p:sp>
        <p:nvSpPr>
          <p:cNvPr id="6" name="Footer Placeholder 5">
            <a:extLst>
              <a:ext uri="{FF2B5EF4-FFF2-40B4-BE49-F238E27FC236}">
                <a16:creationId xmlns:a16="http://schemas.microsoft.com/office/drawing/2014/main" id="{B847F8C5-2C6C-AB06-5B38-E2D9C9D2252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ABD5FB8-5343-78AC-76E9-1FA1A1D03E62}"/>
              </a:ext>
            </a:extLst>
          </p:cNvPr>
          <p:cNvSpPr>
            <a:spLocks noGrp="1"/>
          </p:cNvSpPr>
          <p:nvPr>
            <p:ph type="sldNum" sz="quarter" idx="12"/>
          </p:nvPr>
        </p:nvSpPr>
        <p:spPr/>
        <p:txBody>
          <a:bodyPr/>
          <a:lstStyle/>
          <a:p>
            <a:fld id="{16257D60-74C7-DF4F-AEC8-23B87E802932}" type="slidenum">
              <a:rPr lang="en-US" smtClean="0"/>
              <a:t>‹#›</a:t>
            </a:fld>
            <a:endParaRPr lang="en-US"/>
          </a:p>
        </p:txBody>
      </p:sp>
    </p:spTree>
    <p:extLst>
      <p:ext uri="{BB962C8B-B14F-4D97-AF65-F5344CB8AC3E}">
        <p14:creationId xmlns:p14="http://schemas.microsoft.com/office/powerpoint/2010/main" val="17425457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F9A9172-7D18-5FB6-ED23-AF89CAE20C54}"/>
              </a:ext>
            </a:extLst>
          </p:cNvPr>
          <p:cNvSpPr>
            <a:spLocks noGrp="1"/>
          </p:cNvSpPr>
          <p:nvPr>
            <p:ph type="title"/>
          </p:nvPr>
        </p:nvSpPr>
        <p:spPr>
          <a:xfrm>
            <a:off x="838202"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FFC49BDD-69B7-92BA-2044-CDA31548BC8F}"/>
              </a:ext>
            </a:extLst>
          </p:cNvPr>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167B9FF6-6A40-D51B-32C0-FEAC439C173E}"/>
              </a:ext>
            </a:extLst>
          </p:cNvPr>
          <p:cNvSpPr>
            <a:spLocks noGrp="1"/>
          </p:cNvSpPr>
          <p:nvPr>
            <p:ph type="dt" sz="half" idx="2"/>
          </p:nvPr>
        </p:nvSpPr>
        <p:spPr>
          <a:xfrm>
            <a:off x="838201"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BEFAE93-C21E-1948-8FF6-085838AAC2D7}" type="datetimeFigureOut">
              <a:rPr lang="en-US" smtClean="0"/>
              <a:t>1/31/2023</a:t>
            </a:fld>
            <a:endParaRPr lang="en-US"/>
          </a:p>
        </p:txBody>
      </p:sp>
      <p:sp>
        <p:nvSpPr>
          <p:cNvPr id="5" name="Footer Placeholder 4">
            <a:extLst>
              <a:ext uri="{FF2B5EF4-FFF2-40B4-BE49-F238E27FC236}">
                <a16:creationId xmlns:a16="http://schemas.microsoft.com/office/drawing/2014/main" id="{08AAD9FF-098C-575F-7EFB-0889B9FD2A25}"/>
              </a:ext>
            </a:extLst>
          </p:cNvPr>
          <p:cNvSpPr>
            <a:spLocks noGrp="1"/>
          </p:cNvSpPr>
          <p:nvPr>
            <p:ph type="ftr" sz="quarter" idx="3"/>
          </p:nvPr>
        </p:nvSpPr>
        <p:spPr>
          <a:xfrm>
            <a:off x="4038602"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C678393-9679-F0C0-67B9-8763D58B89C5}"/>
              </a:ext>
            </a:extLst>
          </p:cNvPr>
          <p:cNvSpPr>
            <a:spLocks noGrp="1"/>
          </p:cNvSpPr>
          <p:nvPr>
            <p:ph type="sldNum" sz="quarter" idx="4"/>
          </p:nvPr>
        </p:nvSpPr>
        <p:spPr>
          <a:xfrm>
            <a:off x="8610601"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6257D60-74C7-DF4F-AEC8-23B87E802932}" type="slidenum">
              <a:rPr lang="en-US" smtClean="0"/>
              <a:t>‹#›</a:t>
            </a:fld>
            <a:endParaRPr lang="en-US"/>
          </a:p>
        </p:txBody>
      </p:sp>
    </p:spTree>
    <p:extLst>
      <p:ext uri="{BB962C8B-B14F-4D97-AF65-F5344CB8AC3E}">
        <p14:creationId xmlns:p14="http://schemas.microsoft.com/office/powerpoint/2010/main" val="5432214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378"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5" indent="-228595" algn="l" defTabSz="914378"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5" algn="l" defTabSz="914378"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2" indent="-228595" algn="l" defTabSz="914378"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1" indent="-228595"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50" indent="-228595"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9" indent="-228595"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8" indent="-228595"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7" indent="-228595"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6" indent="-228595" algn="l" defTabSz="914378"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8" rtl="0" eaLnBrk="1" latinLnBrk="0" hangingPunct="1">
        <a:defRPr sz="1800" kern="1200">
          <a:solidFill>
            <a:schemeClr val="tx1"/>
          </a:solidFill>
          <a:latin typeface="+mn-lt"/>
          <a:ea typeface="+mn-ea"/>
          <a:cs typeface="+mn-cs"/>
        </a:defRPr>
      </a:lvl1pPr>
      <a:lvl2pPr marL="457189" algn="l" defTabSz="914378" rtl="0" eaLnBrk="1" latinLnBrk="0" hangingPunct="1">
        <a:defRPr sz="1800" kern="1200">
          <a:solidFill>
            <a:schemeClr val="tx1"/>
          </a:solidFill>
          <a:latin typeface="+mn-lt"/>
          <a:ea typeface="+mn-ea"/>
          <a:cs typeface="+mn-cs"/>
        </a:defRPr>
      </a:lvl2pPr>
      <a:lvl3pPr marL="914378" algn="l" defTabSz="914378" rtl="0" eaLnBrk="1" latinLnBrk="0" hangingPunct="1">
        <a:defRPr sz="1800" kern="1200">
          <a:solidFill>
            <a:schemeClr val="tx1"/>
          </a:solidFill>
          <a:latin typeface="+mn-lt"/>
          <a:ea typeface="+mn-ea"/>
          <a:cs typeface="+mn-cs"/>
        </a:defRPr>
      </a:lvl3pPr>
      <a:lvl4pPr marL="1371567" algn="l" defTabSz="914378" rtl="0" eaLnBrk="1" latinLnBrk="0" hangingPunct="1">
        <a:defRPr sz="1800" kern="1200">
          <a:solidFill>
            <a:schemeClr val="tx1"/>
          </a:solidFill>
          <a:latin typeface="+mn-lt"/>
          <a:ea typeface="+mn-ea"/>
          <a:cs typeface="+mn-cs"/>
        </a:defRPr>
      </a:lvl4pPr>
      <a:lvl5pPr marL="1828755" algn="l" defTabSz="914378" rtl="0" eaLnBrk="1" latinLnBrk="0" hangingPunct="1">
        <a:defRPr sz="1800" kern="1200">
          <a:solidFill>
            <a:schemeClr val="tx1"/>
          </a:solidFill>
          <a:latin typeface="+mn-lt"/>
          <a:ea typeface="+mn-ea"/>
          <a:cs typeface="+mn-cs"/>
        </a:defRPr>
      </a:lvl5pPr>
      <a:lvl6pPr marL="2285944" algn="l" defTabSz="914378" rtl="0" eaLnBrk="1" latinLnBrk="0" hangingPunct="1">
        <a:defRPr sz="1800" kern="1200">
          <a:solidFill>
            <a:schemeClr val="tx1"/>
          </a:solidFill>
          <a:latin typeface="+mn-lt"/>
          <a:ea typeface="+mn-ea"/>
          <a:cs typeface="+mn-cs"/>
        </a:defRPr>
      </a:lvl6pPr>
      <a:lvl7pPr marL="2743134" algn="l" defTabSz="914378" rtl="0" eaLnBrk="1" latinLnBrk="0" hangingPunct="1">
        <a:defRPr sz="1800" kern="1200">
          <a:solidFill>
            <a:schemeClr val="tx1"/>
          </a:solidFill>
          <a:latin typeface="+mn-lt"/>
          <a:ea typeface="+mn-ea"/>
          <a:cs typeface="+mn-cs"/>
        </a:defRPr>
      </a:lvl7pPr>
      <a:lvl8pPr marL="3200322" algn="l" defTabSz="914378" rtl="0" eaLnBrk="1" latinLnBrk="0" hangingPunct="1">
        <a:defRPr sz="1800" kern="1200">
          <a:solidFill>
            <a:schemeClr val="tx1"/>
          </a:solidFill>
          <a:latin typeface="+mn-lt"/>
          <a:ea typeface="+mn-ea"/>
          <a:cs typeface="+mn-cs"/>
        </a:defRPr>
      </a:lvl8pPr>
      <a:lvl9pPr marL="3657511" algn="l" defTabSz="914378"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7E3D17B-8802-7A3E-AD9B-EFE128C80F78}"/>
              </a:ext>
            </a:extLst>
          </p:cNvPr>
          <p:cNvPicPr>
            <a:picLocks noChangeAspect="1"/>
          </p:cNvPicPr>
          <p:nvPr/>
        </p:nvPicPr>
        <p:blipFill rotWithShape="1">
          <a:blip r:embed="rId2"/>
          <a:srcRect t="15661" b="12804"/>
          <a:stretch/>
        </p:blipFill>
        <p:spPr>
          <a:xfrm>
            <a:off x="1243533" y="1074057"/>
            <a:ext cx="9704934" cy="4905830"/>
          </a:xfrm>
          <a:prstGeom prst="rect">
            <a:avLst/>
          </a:prstGeom>
        </p:spPr>
      </p:pic>
      <p:sp>
        <p:nvSpPr>
          <p:cNvPr id="6" name="TextBox 5">
            <a:extLst>
              <a:ext uri="{FF2B5EF4-FFF2-40B4-BE49-F238E27FC236}">
                <a16:creationId xmlns:a16="http://schemas.microsoft.com/office/drawing/2014/main" id="{19513A57-B7A8-09DB-2AAE-5AFDE2ABA4F0}"/>
              </a:ext>
            </a:extLst>
          </p:cNvPr>
          <p:cNvSpPr txBox="1"/>
          <p:nvPr/>
        </p:nvSpPr>
        <p:spPr>
          <a:xfrm>
            <a:off x="2075543" y="427726"/>
            <a:ext cx="5000921" cy="646331"/>
          </a:xfrm>
          <a:prstGeom prst="rect">
            <a:avLst/>
          </a:prstGeom>
          <a:noFill/>
        </p:spPr>
        <p:txBody>
          <a:bodyPr wrap="none" rtlCol="0">
            <a:spAutoFit/>
          </a:bodyPr>
          <a:lstStyle/>
          <a:p>
            <a:r>
              <a:rPr lang="en-US" b="1" dirty="0"/>
              <a:t>Supplementary Figure S1:</a:t>
            </a:r>
            <a:r>
              <a:rPr lang="en-US" dirty="0"/>
              <a:t> </a:t>
            </a:r>
          </a:p>
          <a:p>
            <a:r>
              <a:rPr lang="en-US" dirty="0"/>
              <a:t>Descriptive overview of the tests within OCS-Bridge</a:t>
            </a:r>
          </a:p>
        </p:txBody>
      </p:sp>
    </p:spTree>
    <p:extLst>
      <p:ext uri="{BB962C8B-B14F-4D97-AF65-F5344CB8AC3E}">
        <p14:creationId xmlns:p14="http://schemas.microsoft.com/office/powerpoint/2010/main" val="36938876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944A900D-B5D2-1421-8272-59DF02FCC3D1}"/>
              </a:ext>
            </a:extLst>
          </p:cNvPr>
          <p:cNvPicPr>
            <a:picLocks noChangeAspect="1"/>
          </p:cNvPicPr>
          <p:nvPr/>
        </p:nvPicPr>
        <p:blipFill>
          <a:blip r:embed="rId3"/>
          <a:stretch>
            <a:fillRect/>
          </a:stretch>
        </p:blipFill>
        <p:spPr>
          <a:xfrm>
            <a:off x="1562100" y="684087"/>
            <a:ext cx="9067800" cy="6045200"/>
          </a:xfrm>
          <a:prstGeom prst="rect">
            <a:avLst/>
          </a:prstGeom>
        </p:spPr>
      </p:pic>
      <p:sp>
        <p:nvSpPr>
          <p:cNvPr id="2" name="TextBox 1">
            <a:extLst>
              <a:ext uri="{FF2B5EF4-FFF2-40B4-BE49-F238E27FC236}">
                <a16:creationId xmlns:a16="http://schemas.microsoft.com/office/drawing/2014/main" id="{9E883060-081C-C344-3C1A-5526352A4CB0}"/>
              </a:ext>
            </a:extLst>
          </p:cNvPr>
          <p:cNvSpPr txBox="1"/>
          <p:nvPr/>
        </p:nvSpPr>
        <p:spPr>
          <a:xfrm>
            <a:off x="215900" y="128713"/>
            <a:ext cx="9942017" cy="523220"/>
          </a:xfrm>
          <a:prstGeom prst="rect">
            <a:avLst/>
          </a:prstGeom>
          <a:noFill/>
        </p:spPr>
        <p:txBody>
          <a:bodyPr wrap="none" rtlCol="0">
            <a:spAutoFit/>
          </a:bodyPr>
          <a:lstStyle/>
          <a:p>
            <a:r>
              <a:rPr lang="en-US" sz="1400" b="1" dirty="0"/>
              <a:t>Supplementary Figure S2:</a:t>
            </a:r>
          </a:p>
          <a:p>
            <a:r>
              <a:rPr lang="en-US" sz="1400" dirty="0"/>
              <a:t>Scatterplots for visual assessment of the association between covariates (by column) and cognitive deficit (by row) before surgery (A1)</a:t>
            </a:r>
          </a:p>
        </p:txBody>
      </p:sp>
    </p:spTree>
    <p:extLst>
      <p:ext uri="{BB962C8B-B14F-4D97-AF65-F5344CB8AC3E}">
        <p14:creationId xmlns:p14="http://schemas.microsoft.com/office/powerpoint/2010/main" val="427393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979FEE9-2FE3-5FFE-D93B-66EC70E7EDAE}"/>
              </a:ext>
            </a:extLst>
          </p:cNvPr>
          <p:cNvPicPr>
            <a:picLocks noChangeAspect="1"/>
          </p:cNvPicPr>
          <p:nvPr/>
        </p:nvPicPr>
        <p:blipFill>
          <a:blip r:embed="rId3"/>
          <a:stretch>
            <a:fillRect/>
          </a:stretch>
        </p:blipFill>
        <p:spPr>
          <a:xfrm>
            <a:off x="366184" y="973365"/>
            <a:ext cx="11459632" cy="4911271"/>
          </a:xfrm>
          <a:prstGeom prst="rect">
            <a:avLst/>
          </a:prstGeom>
        </p:spPr>
      </p:pic>
      <p:sp>
        <p:nvSpPr>
          <p:cNvPr id="2" name="TextBox 1">
            <a:extLst>
              <a:ext uri="{FF2B5EF4-FFF2-40B4-BE49-F238E27FC236}">
                <a16:creationId xmlns:a16="http://schemas.microsoft.com/office/drawing/2014/main" id="{334573E8-89EE-EF25-E8DC-AF87443CFF31}"/>
              </a:ext>
            </a:extLst>
          </p:cNvPr>
          <p:cNvSpPr txBox="1"/>
          <p:nvPr/>
        </p:nvSpPr>
        <p:spPr>
          <a:xfrm>
            <a:off x="0" y="101600"/>
            <a:ext cx="10307886" cy="523220"/>
          </a:xfrm>
          <a:prstGeom prst="rect">
            <a:avLst/>
          </a:prstGeom>
          <a:noFill/>
        </p:spPr>
        <p:txBody>
          <a:bodyPr wrap="none" rtlCol="0">
            <a:spAutoFit/>
          </a:bodyPr>
          <a:lstStyle/>
          <a:p>
            <a:r>
              <a:rPr lang="en-US" sz="1400" b="1" dirty="0"/>
              <a:t>Supplementary Figure S3:</a:t>
            </a:r>
          </a:p>
          <a:p>
            <a:r>
              <a:rPr lang="en-US" sz="1400" dirty="0"/>
              <a:t>Scatterplots for visual assessment of the association between covariates (by column) and cognitive deficit (by row) early after surgery (A2)</a:t>
            </a:r>
            <a:endParaRPr lang="en-US" dirty="0"/>
          </a:p>
        </p:txBody>
      </p:sp>
    </p:spTree>
    <p:extLst>
      <p:ext uri="{BB962C8B-B14F-4D97-AF65-F5344CB8AC3E}">
        <p14:creationId xmlns:p14="http://schemas.microsoft.com/office/powerpoint/2010/main" val="42460518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F2D1A8A-96A8-B86A-E3A1-49781370E420}"/>
              </a:ext>
            </a:extLst>
          </p:cNvPr>
          <p:cNvPicPr>
            <a:picLocks noChangeAspect="1"/>
          </p:cNvPicPr>
          <p:nvPr/>
        </p:nvPicPr>
        <p:blipFill>
          <a:blip r:embed="rId3"/>
          <a:stretch>
            <a:fillRect/>
          </a:stretch>
        </p:blipFill>
        <p:spPr>
          <a:xfrm>
            <a:off x="533400" y="1269999"/>
            <a:ext cx="10896599" cy="4669971"/>
          </a:xfrm>
          <a:prstGeom prst="rect">
            <a:avLst/>
          </a:prstGeom>
        </p:spPr>
      </p:pic>
      <p:sp>
        <p:nvSpPr>
          <p:cNvPr id="2" name="TextBox 1">
            <a:extLst>
              <a:ext uri="{FF2B5EF4-FFF2-40B4-BE49-F238E27FC236}">
                <a16:creationId xmlns:a16="http://schemas.microsoft.com/office/drawing/2014/main" id="{0F85A424-A4A1-8753-AE19-16487562B8B2}"/>
              </a:ext>
            </a:extLst>
          </p:cNvPr>
          <p:cNvSpPr txBox="1"/>
          <p:nvPr/>
        </p:nvSpPr>
        <p:spPr>
          <a:xfrm>
            <a:off x="88900" y="77765"/>
            <a:ext cx="11202875" cy="738664"/>
          </a:xfrm>
          <a:prstGeom prst="rect">
            <a:avLst/>
          </a:prstGeom>
          <a:noFill/>
        </p:spPr>
        <p:txBody>
          <a:bodyPr wrap="none" rtlCol="0">
            <a:spAutoFit/>
          </a:bodyPr>
          <a:lstStyle/>
          <a:p>
            <a:r>
              <a:rPr lang="en-US" sz="1400" b="1" dirty="0"/>
              <a:t>Supplementary Figure S4:</a:t>
            </a:r>
            <a:endParaRPr lang="en-US" sz="1400" dirty="0"/>
          </a:p>
          <a:p>
            <a:r>
              <a:rPr lang="en-US" sz="1400" dirty="0"/>
              <a:t>Scatterplots for visual assessment of the association between covariates (by column) and change in cognitive deficit status (by row) between A1 and A2</a:t>
            </a:r>
          </a:p>
          <a:p>
            <a:endParaRPr lang="en-US" sz="1400" dirty="0"/>
          </a:p>
        </p:txBody>
      </p:sp>
    </p:spTree>
    <p:extLst>
      <p:ext uri="{BB962C8B-B14F-4D97-AF65-F5344CB8AC3E}">
        <p14:creationId xmlns:p14="http://schemas.microsoft.com/office/powerpoint/2010/main" val="16422741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477BC75-D169-2C19-17B8-6482CE5D90F2}"/>
              </a:ext>
            </a:extLst>
          </p:cNvPr>
          <p:cNvSpPr txBox="1"/>
          <p:nvPr/>
        </p:nvSpPr>
        <p:spPr>
          <a:xfrm rot="16200000">
            <a:off x="-2844224" y="2844223"/>
            <a:ext cx="6858001" cy="1169551"/>
          </a:xfrm>
          <a:prstGeom prst="rect">
            <a:avLst/>
          </a:prstGeom>
          <a:noFill/>
        </p:spPr>
        <p:txBody>
          <a:bodyPr wrap="square" rtlCol="0">
            <a:spAutoFit/>
          </a:bodyPr>
          <a:lstStyle/>
          <a:p>
            <a:r>
              <a:rPr lang="en-US" sz="1400" b="1" dirty="0"/>
              <a:t>Supplementary Figure S5:</a:t>
            </a:r>
            <a:endParaRPr lang="en-US" sz="1400" dirty="0"/>
          </a:p>
          <a:p>
            <a:r>
              <a:rPr lang="en-US" sz="1400" dirty="0"/>
              <a:t>Prevalence of cognitive deficit in normal control population (N), and at A1, A2 and A3 for each cognitive domain observed in our cohort, shown both as histograms (A) and pictorial representations (B). </a:t>
            </a:r>
          </a:p>
          <a:p>
            <a:endParaRPr lang="en-US" sz="1400" dirty="0"/>
          </a:p>
        </p:txBody>
      </p:sp>
      <p:pic>
        <p:nvPicPr>
          <p:cNvPr id="6" name="Picture 5">
            <a:extLst>
              <a:ext uri="{FF2B5EF4-FFF2-40B4-BE49-F238E27FC236}">
                <a16:creationId xmlns:a16="http://schemas.microsoft.com/office/drawing/2014/main" id="{2A984075-6585-47DD-06E0-429DABB9F36D}"/>
              </a:ext>
            </a:extLst>
          </p:cNvPr>
          <p:cNvPicPr>
            <a:picLocks noChangeAspect="1"/>
          </p:cNvPicPr>
          <p:nvPr/>
        </p:nvPicPr>
        <p:blipFill>
          <a:blip r:embed="rId2"/>
          <a:stretch>
            <a:fillRect/>
          </a:stretch>
        </p:blipFill>
        <p:spPr>
          <a:xfrm rot="16200000">
            <a:off x="3152042" y="-1751429"/>
            <a:ext cx="6743280" cy="10384137"/>
          </a:xfrm>
          <a:prstGeom prst="rect">
            <a:avLst/>
          </a:prstGeom>
        </p:spPr>
      </p:pic>
      <p:sp>
        <p:nvSpPr>
          <p:cNvPr id="7" name="TextBox 6">
            <a:extLst>
              <a:ext uri="{FF2B5EF4-FFF2-40B4-BE49-F238E27FC236}">
                <a16:creationId xmlns:a16="http://schemas.microsoft.com/office/drawing/2014/main" id="{278BAF6B-7807-ED5C-422D-C16FC4F79ACE}"/>
              </a:ext>
            </a:extLst>
          </p:cNvPr>
          <p:cNvSpPr txBox="1"/>
          <p:nvPr/>
        </p:nvSpPr>
        <p:spPr>
          <a:xfrm rot="16200000">
            <a:off x="1618588" y="3577204"/>
            <a:ext cx="4709160" cy="182880"/>
          </a:xfrm>
          <a:prstGeom prst="rect">
            <a:avLst/>
          </a:prstGeom>
          <a:solidFill>
            <a:schemeClr val="bg1"/>
          </a:solidFill>
        </p:spPr>
        <p:txBody>
          <a:bodyPr wrap="square" rtlCol="0">
            <a:spAutoFit/>
          </a:bodyPr>
          <a:lstStyle/>
          <a:p>
            <a:endParaRPr lang="en-US" dirty="0"/>
          </a:p>
        </p:txBody>
      </p:sp>
      <p:sp>
        <p:nvSpPr>
          <p:cNvPr id="8" name="TextBox 7">
            <a:extLst>
              <a:ext uri="{FF2B5EF4-FFF2-40B4-BE49-F238E27FC236}">
                <a16:creationId xmlns:a16="http://schemas.microsoft.com/office/drawing/2014/main" id="{3CB63B93-E4C9-4FD8-B77C-1649EE5A8386}"/>
              </a:ext>
            </a:extLst>
          </p:cNvPr>
          <p:cNvSpPr txBox="1"/>
          <p:nvPr/>
        </p:nvSpPr>
        <p:spPr>
          <a:xfrm rot="16200000">
            <a:off x="3540196" y="5413132"/>
            <a:ext cx="865943" cy="261610"/>
          </a:xfrm>
          <a:prstGeom prst="rect">
            <a:avLst/>
          </a:prstGeom>
          <a:noFill/>
        </p:spPr>
        <p:txBody>
          <a:bodyPr wrap="none" rtlCol="0">
            <a:spAutoFit/>
          </a:bodyPr>
          <a:lstStyle/>
          <a:p>
            <a:r>
              <a:rPr lang="en-US" sz="1100" dirty="0"/>
              <a:t>N  A1 A2 A3</a:t>
            </a:r>
          </a:p>
        </p:txBody>
      </p:sp>
      <p:sp>
        <p:nvSpPr>
          <p:cNvPr id="9" name="TextBox 8">
            <a:extLst>
              <a:ext uri="{FF2B5EF4-FFF2-40B4-BE49-F238E27FC236}">
                <a16:creationId xmlns:a16="http://schemas.microsoft.com/office/drawing/2014/main" id="{60E54C05-70DB-57AA-2CF9-668366150D5D}"/>
              </a:ext>
            </a:extLst>
          </p:cNvPr>
          <p:cNvSpPr txBox="1"/>
          <p:nvPr/>
        </p:nvSpPr>
        <p:spPr>
          <a:xfrm rot="16200000">
            <a:off x="3539232" y="4624075"/>
            <a:ext cx="865943" cy="261610"/>
          </a:xfrm>
          <a:prstGeom prst="rect">
            <a:avLst/>
          </a:prstGeom>
          <a:noFill/>
        </p:spPr>
        <p:txBody>
          <a:bodyPr wrap="none" rtlCol="0">
            <a:spAutoFit/>
          </a:bodyPr>
          <a:lstStyle/>
          <a:p>
            <a:r>
              <a:rPr lang="en-US" sz="1100" dirty="0"/>
              <a:t>N  A1 A2 A3</a:t>
            </a:r>
          </a:p>
        </p:txBody>
      </p:sp>
      <p:sp>
        <p:nvSpPr>
          <p:cNvPr id="10" name="TextBox 9">
            <a:extLst>
              <a:ext uri="{FF2B5EF4-FFF2-40B4-BE49-F238E27FC236}">
                <a16:creationId xmlns:a16="http://schemas.microsoft.com/office/drawing/2014/main" id="{D6FEE001-B633-2AE5-009F-F80E7BD395B3}"/>
              </a:ext>
            </a:extLst>
          </p:cNvPr>
          <p:cNvSpPr txBox="1"/>
          <p:nvPr/>
        </p:nvSpPr>
        <p:spPr>
          <a:xfrm rot="16200000">
            <a:off x="3538267" y="3835017"/>
            <a:ext cx="865943" cy="261610"/>
          </a:xfrm>
          <a:prstGeom prst="rect">
            <a:avLst/>
          </a:prstGeom>
          <a:noFill/>
        </p:spPr>
        <p:txBody>
          <a:bodyPr wrap="none" rtlCol="0">
            <a:spAutoFit/>
          </a:bodyPr>
          <a:lstStyle/>
          <a:p>
            <a:r>
              <a:rPr lang="en-US" sz="1100" dirty="0"/>
              <a:t>N  A1 A2 A3</a:t>
            </a:r>
          </a:p>
        </p:txBody>
      </p:sp>
      <p:sp>
        <p:nvSpPr>
          <p:cNvPr id="11" name="TextBox 10">
            <a:extLst>
              <a:ext uri="{FF2B5EF4-FFF2-40B4-BE49-F238E27FC236}">
                <a16:creationId xmlns:a16="http://schemas.microsoft.com/office/drawing/2014/main" id="{93B98365-C48B-35DD-6957-59E2E40681DE}"/>
              </a:ext>
            </a:extLst>
          </p:cNvPr>
          <p:cNvSpPr txBox="1"/>
          <p:nvPr/>
        </p:nvSpPr>
        <p:spPr>
          <a:xfrm rot="16200000">
            <a:off x="3537301" y="3081709"/>
            <a:ext cx="865943" cy="261610"/>
          </a:xfrm>
          <a:prstGeom prst="rect">
            <a:avLst/>
          </a:prstGeom>
          <a:noFill/>
        </p:spPr>
        <p:txBody>
          <a:bodyPr wrap="none" rtlCol="0">
            <a:spAutoFit/>
          </a:bodyPr>
          <a:lstStyle/>
          <a:p>
            <a:r>
              <a:rPr lang="en-US" sz="1100" dirty="0"/>
              <a:t>N  A1 A2 A3</a:t>
            </a:r>
          </a:p>
        </p:txBody>
      </p:sp>
      <p:sp>
        <p:nvSpPr>
          <p:cNvPr id="12" name="TextBox 11">
            <a:extLst>
              <a:ext uri="{FF2B5EF4-FFF2-40B4-BE49-F238E27FC236}">
                <a16:creationId xmlns:a16="http://schemas.microsoft.com/office/drawing/2014/main" id="{C7DB11C1-0E98-B336-ADF0-F3A734A1E67D}"/>
              </a:ext>
            </a:extLst>
          </p:cNvPr>
          <p:cNvSpPr txBox="1"/>
          <p:nvPr/>
        </p:nvSpPr>
        <p:spPr>
          <a:xfrm rot="16200000">
            <a:off x="3537301" y="2292651"/>
            <a:ext cx="865943" cy="261610"/>
          </a:xfrm>
          <a:prstGeom prst="rect">
            <a:avLst/>
          </a:prstGeom>
          <a:noFill/>
        </p:spPr>
        <p:txBody>
          <a:bodyPr wrap="none" rtlCol="0">
            <a:spAutoFit/>
          </a:bodyPr>
          <a:lstStyle/>
          <a:p>
            <a:r>
              <a:rPr lang="en-US" sz="1100" dirty="0"/>
              <a:t>N  A1 A2 A3</a:t>
            </a:r>
          </a:p>
        </p:txBody>
      </p:sp>
      <p:sp>
        <p:nvSpPr>
          <p:cNvPr id="13" name="TextBox 12">
            <a:extLst>
              <a:ext uri="{FF2B5EF4-FFF2-40B4-BE49-F238E27FC236}">
                <a16:creationId xmlns:a16="http://schemas.microsoft.com/office/drawing/2014/main" id="{3D5AE033-5515-FF76-B387-673D561F655C}"/>
              </a:ext>
            </a:extLst>
          </p:cNvPr>
          <p:cNvSpPr txBox="1"/>
          <p:nvPr/>
        </p:nvSpPr>
        <p:spPr>
          <a:xfrm rot="16200000">
            <a:off x="3537300" y="1503594"/>
            <a:ext cx="865943" cy="261610"/>
          </a:xfrm>
          <a:prstGeom prst="rect">
            <a:avLst/>
          </a:prstGeom>
          <a:noFill/>
        </p:spPr>
        <p:txBody>
          <a:bodyPr wrap="none" rtlCol="0">
            <a:spAutoFit/>
          </a:bodyPr>
          <a:lstStyle/>
          <a:p>
            <a:r>
              <a:rPr lang="en-US" sz="1100" dirty="0"/>
              <a:t>N  A1 A2 A3</a:t>
            </a:r>
          </a:p>
        </p:txBody>
      </p:sp>
      <p:sp>
        <p:nvSpPr>
          <p:cNvPr id="14" name="TextBox 13">
            <a:extLst>
              <a:ext uri="{FF2B5EF4-FFF2-40B4-BE49-F238E27FC236}">
                <a16:creationId xmlns:a16="http://schemas.microsoft.com/office/drawing/2014/main" id="{618036DB-1E63-B54D-13CE-5FE12B6AC84F}"/>
              </a:ext>
            </a:extLst>
          </p:cNvPr>
          <p:cNvSpPr txBox="1"/>
          <p:nvPr/>
        </p:nvSpPr>
        <p:spPr>
          <a:xfrm rot="16200000">
            <a:off x="4062444" y="4075542"/>
            <a:ext cx="385042" cy="307777"/>
          </a:xfrm>
          <a:prstGeom prst="rect">
            <a:avLst/>
          </a:prstGeom>
          <a:solidFill>
            <a:schemeClr val="bg1"/>
          </a:solidFill>
        </p:spPr>
        <p:txBody>
          <a:bodyPr wrap="none" rtlCol="0">
            <a:spAutoFit/>
          </a:bodyPr>
          <a:lstStyle/>
          <a:p>
            <a:r>
              <a:rPr lang="en-US" sz="1400" b="1" dirty="0"/>
              <a:t>A1</a:t>
            </a:r>
            <a:endParaRPr lang="en-US" sz="1100" b="1" dirty="0"/>
          </a:p>
        </p:txBody>
      </p:sp>
      <p:sp>
        <p:nvSpPr>
          <p:cNvPr id="15" name="TextBox 14">
            <a:extLst>
              <a:ext uri="{FF2B5EF4-FFF2-40B4-BE49-F238E27FC236}">
                <a16:creationId xmlns:a16="http://schemas.microsoft.com/office/drawing/2014/main" id="{B2B65161-8CA4-A1E5-6A8D-10AA05499198}"/>
              </a:ext>
            </a:extLst>
          </p:cNvPr>
          <p:cNvSpPr txBox="1"/>
          <p:nvPr/>
        </p:nvSpPr>
        <p:spPr>
          <a:xfrm rot="16200000">
            <a:off x="4034147" y="2662003"/>
            <a:ext cx="385042" cy="307777"/>
          </a:xfrm>
          <a:prstGeom prst="rect">
            <a:avLst/>
          </a:prstGeom>
          <a:solidFill>
            <a:schemeClr val="bg1"/>
          </a:solidFill>
        </p:spPr>
        <p:txBody>
          <a:bodyPr wrap="none" rtlCol="0">
            <a:spAutoFit/>
          </a:bodyPr>
          <a:lstStyle/>
          <a:p>
            <a:r>
              <a:rPr lang="en-US" sz="1400" b="1" dirty="0"/>
              <a:t>A2</a:t>
            </a:r>
            <a:endParaRPr lang="en-US" sz="1100" b="1" dirty="0"/>
          </a:p>
        </p:txBody>
      </p:sp>
      <p:sp>
        <p:nvSpPr>
          <p:cNvPr id="16" name="TextBox 15">
            <a:extLst>
              <a:ext uri="{FF2B5EF4-FFF2-40B4-BE49-F238E27FC236}">
                <a16:creationId xmlns:a16="http://schemas.microsoft.com/office/drawing/2014/main" id="{790783CB-689A-3A7F-0FC7-836E1E2B8713}"/>
              </a:ext>
            </a:extLst>
          </p:cNvPr>
          <p:cNvSpPr txBox="1"/>
          <p:nvPr/>
        </p:nvSpPr>
        <p:spPr>
          <a:xfrm rot="16200000">
            <a:off x="4025975" y="1381856"/>
            <a:ext cx="385042" cy="307777"/>
          </a:xfrm>
          <a:prstGeom prst="rect">
            <a:avLst/>
          </a:prstGeom>
          <a:solidFill>
            <a:schemeClr val="bg1"/>
          </a:solidFill>
        </p:spPr>
        <p:txBody>
          <a:bodyPr wrap="none" rtlCol="0">
            <a:spAutoFit/>
          </a:bodyPr>
          <a:lstStyle/>
          <a:p>
            <a:r>
              <a:rPr lang="en-US" sz="1400" b="1" dirty="0"/>
              <a:t>A3</a:t>
            </a:r>
            <a:endParaRPr lang="en-US" sz="1100" b="1" dirty="0"/>
          </a:p>
        </p:txBody>
      </p:sp>
    </p:spTree>
    <p:extLst>
      <p:ext uri="{BB962C8B-B14F-4D97-AF65-F5344CB8AC3E}">
        <p14:creationId xmlns:p14="http://schemas.microsoft.com/office/powerpoint/2010/main" val="15274330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9C2A1B7-C5EB-AA0E-1E15-27A3CDE6A1B7}"/>
              </a:ext>
            </a:extLst>
          </p:cNvPr>
          <p:cNvSpPr txBox="1"/>
          <p:nvPr/>
        </p:nvSpPr>
        <p:spPr>
          <a:xfrm>
            <a:off x="122464" y="0"/>
            <a:ext cx="12192000" cy="1107996"/>
          </a:xfrm>
          <a:prstGeom prst="rect">
            <a:avLst/>
          </a:prstGeom>
          <a:noFill/>
        </p:spPr>
        <p:txBody>
          <a:bodyPr wrap="square">
            <a:spAutoFit/>
          </a:bodyPr>
          <a:lstStyle/>
          <a:p>
            <a:r>
              <a:rPr lang="en-US" b="1" dirty="0"/>
              <a:t>Supplementary Figure S6.</a:t>
            </a:r>
            <a:r>
              <a:rPr lang="en-US" dirty="0"/>
              <a:t> </a:t>
            </a:r>
          </a:p>
          <a:p>
            <a:r>
              <a:rPr lang="en-US" sz="1200" dirty="0"/>
              <a:t>Risk of cognitive deficit at A1 and A2 in our glioblastoma cohort shown alongside other common intuitively understood risks. White boxes express the annual risk of death in Britain for various causes</a:t>
            </a:r>
            <a:r>
              <a:rPr lang="en-US" sz="1200" baseline="30000" dirty="0"/>
              <a:t>1</a:t>
            </a:r>
            <a:r>
              <a:rPr lang="en-US" sz="1200" dirty="0"/>
              <a:t>. Green boxes express the fatality rate associated with the covid vaccination</a:t>
            </a:r>
            <a:r>
              <a:rPr lang="en-US" sz="1200" baseline="30000" dirty="0"/>
              <a:t>2</a:t>
            </a:r>
            <a:r>
              <a:rPr lang="en-US" sz="1200" dirty="0"/>
              <a:t>, covid infection in unvaccinated individuals</a:t>
            </a:r>
            <a:r>
              <a:rPr lang="en-US" sz="1200" baseline="30000" dirty="0"/>
              <a:t>3</a:t>
            </a:r>
            <a:r>
              <a:rPr lang="en-US" sz="1200" dirty="0"/>
              <a:t>, and covid infection in vaccinated individuals</a:t>
            </a:r>
            <a:r>
              <a:rPr lang="en-US" sz="1200" baseline="30000" dirty="0"/>
              <a:t>4</a:t>
            </a:r>
            <a:r>
              <a:rPr lang="en-US" sz="1200" dirty="0"/>
              <a:t>. The gray box indicates the “Normal” risk of cognitive deficit in the domain, whilst the blue and red boxes mark the risk in patients with glioblastoma before (A1) and 1 week after (A2) surgery, respectively. Two exemplary domains are shown: (A) Language, and (B) Attention. </a:t>
            </a:r>
          </a:p>
        </p:txBody>
      </p:sp>
      <p:grpSp>
        <p:nvGrpSpPr>
          <p:cNvPr id="4" name="Group 3">
            <a:extLst>
              <a:ext uri="{FF2B5EF4-FFF2-40B4-BE49-F238E27FC236}">
                <a16:creationId xmlns:a16="http://schemas.microsoft.com/office/drawing/2014/main" id="{E4C2FB41-AB21-A54C-9C11-BE6BD9F58E21}"/>
              </a:ext>
            </a:extLst>
          </p:cNvPr>
          <p:cNvGrpSpPr/>
          <p:nvPr/>
        </p:nvGrpSpPr>
        <p:grpSpPr>
          <a:xfrm>
            <a:off x="3522133" y="1135559"/>
            <a:ext cx="6858000" cy="5019708"/>
            <a:chOff x="3526301" y="1140373"/>
            <a:chExt cx="6962488" cy="5140416"/>
          </a:xfrm>
        </p:grpSpPr>
        <p:grpSp>
          <p:nvGrpSpPr>
            <p:cNvPr id="3" name="Group 2">
              <a:extLst>
                <a:ext uri="{FF2B5EF4-FFF2-40B4-BE49-F238E27FC236}">
                  <a16:creationId xmlns:a16="http://schemas.microsoft.com/office/drawing/2014/main" id="{D7B00FCC-FB45-3A4C-A970-731509E49627}"/>
                </a:ext>
              </a:extLst>
            </p:cNvPr>
            <p:cNvGrpSpPr/>
            <p:nvPr/>
          </p:nvGrpSpPr>
          <p:grpSpPr>
            <a:xfrm>
              <a:off x="3526301" y="1140373"/>
              <a:ext cx="6962488" cy="5140416"/>
              <a:chOff x="3516776" y="1137198"/>
              <a:chExt cx="6962488" cy="5140416"/>
            </a:xfrm>
          </p:grpSpPr>
          <p:pic>
            <p:nvPicPr>
              <p:cNvPr id="7" name="Picture 6">
                <a:extLst>
                  <a:ext uri="{FF2B5EF4-FFF2-40B4-BE49-F238E27FC236}">
                    <a16:creationId xmlns:a16="http://schemas.microsoft.com/office/drawing/2014/main" id="{12832BCE-7F6F-CEBE-88B4-4133C8CAFA24}"/>
                  </a:ext>
                </a:extLst>
              </p:cNvPr>
              <p:cNvPicPr>
                <a:picLocks noChangeAspect="1"/>
              </p:cNvPicPr>
              <p:nvPr/>
            </p:nvPicPr>
            <p:blipFill>
              <a:blip r:embed="rId2"/>
              <a:stretch>
                <a:fillRect/>
              </a:stretch>
            </p:blipFill>
            <p:spPr>
              <a:xfrm>
                <a:off x="3516776" y="1137198"/>
                <a:ext cx="6962488" cy="5140416"/>
              </a:xfrm>
              <a:prstGeom prst="rect">
                <a:avLst/>
              </a:prstGeom>
            </p:spPr>
          </p:pic>
          <p:sp>
            <p:nvSpPr>
              <p:cNvPr id="8" name="Rectangle 7">
                <a:extLst>
                  <a:ext uri="{FF2B5EF4-FFF2-40B4-BE49-F238E27FC236}">
                    <a16:creationId xmlns:a16="http://schemas.microsoft.com/office/drawing/2014/main" id="{4CE29AD2-583B-AB4D-6447-575505F1AEA8}"/>
                  </a:ext>
                </a:extLst>
              </p:cNvPr>
              <p:cNvSpPr/>
              <p:nvPr/>
            </p:nvSpPr>
            <p:spPr>
              <a:xfrm>
                <a:off x="9906719" y="2255889"/>
                <a:ext cx="85725" cy="76200"/>
              </a:xfrm>
              <a:prstGeom prst="rect">
                <a:avLst/>
              </a:prstGeom>
              <a:solidFill>
                <a:srgbClr val="DC2B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94C0A8CA-8263-FAE6-2512-77B5CA35901F}"/>
                  </a:ext>
                </a:extLst>
              </p:cNvPr>
              <p:cNvSpPr/>
              <p:nvPr/>
            </p:nvSpPr>
            <p:spPr>
              <a:xfrm>
                <a:off x="9695056" y="2533966"/>
                <a:ext cx="85725" cy="76200"/>
              </a:xfrm>
              <a:prstGeom prst="rect">
                <a:avLst/>
              </a:prstGeom>
              <a:solidFill>
                <a:srgbClr val="3C548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BA86B1B7-1666-D28E-39B3-E7EEE2D59DCE}"/>
                  </a:ext>
                </a:extLst>
              </p:cNvPr>
              <p:cNvSpPr/>
              <p:nvPr/>
            </p:nvSpPr>
            <p:spPr>
              <a:xfrm>
                <a:off x="10112918" y="4714875"/>
                <a:ext cx="77829" cy="78792"/>
              </a:xfrm>
              <a:prstGeom prst="rect">
                <a:avLst/>
              </a:prstGeom>
              <a:solidFill>
                <a:srgbClr val="DC2B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CFC17730-6288-7D3E-FCBD-44CE93E9EADF}"/>
                  </a:ext>
                </a:extLst>
              </p:cNvPr>
              <p:cNvSpPr/>
              <p:nvPr/>
            </p:nvSpPr>
            <p:spPr>
              <a:xfrm>
                <a:off x="9996664" y="4975784"/>
                <a:ext cx="85725" cy="76200"/>
              </a:xfrm>
              <a:prstGeom prst="rect">
                <a:avLst/>
              </a:prstGeom>
              <a:solidFill>
                <a:srgbClr val="3C548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1" name="TextBox 10">
              <a:extLst>
                <a:ext uri="{FF2B5EF4-FFF2-40B4-BE49-F238E27FC236}">
                  <a16:creationId xmlns:a16="http://schemas.microsoft.com/office/drawing/2014/main" id="{9BA4438C-51F1-9E11-9EA1-8EEB0EDF7E6D}"/>
                </a:ext>
              </a:extLst>
            </p:cNvPr>
            <p:cNvSpPr txBox="1"/>
            <p:nvPr/>
          </p:nvSpPr>
          <p:spPr>
            <a:xfrm>
              <a:off x="9647787" y="2491274"/>
              <a:ext cx="247184" cy="161583"/>
            </a:xfrm>
            <a:prstGeom prst="rect">
              <a:avLst/>
            </a:prstGeom>
            <a:noFill/>
          </p:spPr>
          <p:txBody>
            <a:bodyPr wrap="none" rtlCol="0">
              <a:spAutoFit/>
            </a:bodyPr>
            <a:lstStyle/>
            <a:p>
              <a:r>
                <a:rPr lang="en-US" sz="450" dirty="0">
                  <a:solidFill>
                    <a:schemeClr val="bg1"/>
                  </a:solidFill>
                </a:rPr>
                <a:t>A1</a:t>
              </a:r>
            </a:p>
          </p:txBody>
        </p:sp>
        <p:sp>
          <p:nvSpPr>
            <p:cNvPr id="12" name="TextBox 11">
              <a:extLst>
                <a:ext uri="{FF2B5EF4-FFF2-40B4-BE49-F238E27FC236}">
                  <a16:creationId xmlns:a16="http://schemas.microsoft.com/office/drawing/2014/main" id="{ED91EAD1-292D-39B2-AD97-4FD26DDB592E}"/>
                </a:ext>
              </a:extLst>
            </p:cNvPr>
            <p:cNvSpPr txBox="1"/>
            <p:nvPr/>
          </p:nvSpPr>
          <p:spPr>
            <a:xfrm>
              <a:off x="9835324" y="2213197"/>
              <a:ext cx="263116" cy="161583"/>
            </a:xfrm>
            <a:prstGeom prst="rect">
              <a:avLst/>
            </a:prstGeom>
            <a:noFill/>
          </p:spPr>
          <p:txBody>
            <a:bodyPr wrap="square" rtlCol="0">
              <a:spAutoFit/>
            </a:bodyPr>
            <a:lstStyle/>
            <a:p>
              <a:r>
                <a:rPr lang="en-US" sz="450" dirty="0">
                  <a:solidFill>
                    <a:schemeClr val="bg1"/>
                  </a:solidFill>
                </a:rPr>
                <a:t>A2</a:t>
              </a:r>
            </a:p>
          </p:txBody>
        </p:sp>
        <p:sp>
          <p:nvSpPr>
            <p:cNvPr id="15" name="TextBox 14">
              <a:extLst>
                <a:ext uri="{FF2B5EF4-FFF2-40B4-BE49-F238E27FC236}">
                  <a16:creationId xmlns:a16="http://schemas.microsoft.com/office/drawing/2014/main" id="{E3A71FD1-0FCE-C757-50E8-96BFEFD527E8}"/>
                </a:ext>
              </a:extLst>
            </p:cNvPr>
            <p:cNvSpPr txBox="1"/>
            <p:nvPr/>
          </p:nvSpPr>
          <p:spPr>
            <a:xfrm>
              <a:off x="9925459" y="4935230"/>
              <a:ext cx="247184" cy="161583"/>
            </a:xfrm>
            <a:prstGeom prst="rect">
              <a:avLst/>
            </a:prstGeom>
            <a:noFill/>
          </p:spPr>
          <p:txBody>
            <a:bodyPr wrap="none" rtlCol="0">
              <a:spAutoFit/>
            </a:bodyPr>
            <a:lstStyle/>
            <a:p>
              <a:r>
                <a:rPr lang="en-US" sz="450" dirty="0">
                  <a:solidFill>
                    <a:schemeClr val="bg1"/>
                  </a:solidFill>
                </a:rPr>
                <a:t>A1</a:t>
              </a:r>
            </a:p>
          </p:txBody>
        </p:sp>
        <p:sp>
          <p:nvSpPr>
            <p:cNvPr id="16" name="TextBox 15">
              <a:extLst>
                <a:ext uri="{FF2B5EF4-FFF2-40B4-BE49-F238E27FC236}">
                  <a16:creationId xmlns:a16="http://schemas.microsoft.com/office/drawing/2014/main" id="{810D93DF-34C9-42D0-47B4-BE0C4B4DFA29}"/>
                </a:ext>
              </a:extLst>
            </p:cNvPr>
            <p:cNvSpPr txBox="1"/>
            <p:nvPr/>
          </p:nvSpPr>
          <p:spPr>
            <a:xfrm>
              <a:off x="10037765" y="4676654"/>
              <a:ext cx="247184" cy="161583"/>
            </a:xfrm>
            <a:prstGeom prst="rect">
              <a:avLst/>
            </a:prstGeom>
            <a:noFill/>
          </p:spPr>
          <p:txBody>
            <a:bodyPr wrap="square" rtlCol="0">
              <a:spAutoFit/>
            </a:bodyPr>
            <a:lstStyle/>
            <a:p>
              <a:r>
                <a:rPr lang="en-US" sz="450" dirty="0">
                  <a:solidFill>
                    <a:schemeClr val="bg1"/>
                  </a:solidFill>
                </a:rPr>
                <a:t>A2</a:t>
              </a:r>
            </a:p>
          </p:txBody>
        </p:sp>
      </p:grpSp>
      <p:sp>
        <p:nvSpPr>
          <p:cNvPr id="18" name="TextBox 17">
            <a:extLst>
              <a:ext uri="{FF2B5EF4-FFF2-40B4-BE49-F238E27FC236}">
                <a16:creationId xmlns:a16="http://schemas.microsoft.com/office/drawing/2014/main" id="{45859FA5-DD93-22A2-F466-0AD246031942}"/>
              </a:ext>
            </a:extLst>
          </p:cNvPr>
          <p:cNvSpPr txBox="1"/>
          <p:nvPr/>
        </p:nvSpPr>
        <p:spPr>
          <a:xfrm>
            <a:off x="244929" y="6049736"/>
            <a:ext cx="11947071" cy="830997"/>
          </a:xfrm>
          <a:prstGeom prst="rect">
            <a:avLst/>
          </a:prstGeom>
          <a:noFill/>
        </p:spPr>
        <p:txBody>
          <a:bodyPr wrap="square" rtlCol="0">
            <a:spAutoFit/>
          </a:bodyPr>
          <a:lstStyle/>
          <a:p>
            <a:pPr marL="136525" indent="-136525"/>
            <a:r>
              <a:rPr lang="en-US" sz="800" b="1" dirty="0"/>
              <a:t>References: </a:t>
            </a:r>
          </a:p>
          <a:p>
            <a:r>
              <a:rPr lang="en-US" sz="800" dirty="0"/>
              <a:t>[66] Communicating about risks to public health: pointers to good practice. Peter Bennet et al (1998). Available at: https://www.regulation.org.uk/library/</a:t>
            </a:r>
            <a:r>
              <a:rPr lang="en-US" sz="800" dirty="0" err="1"/>
              <a:t>dh_risk_comms_advice.pdf</a:t>
            </a:r>
            <a:endParaRPr lang="en-US" sz="800" dirty="0"/>
          </a:p>
          <a:p>
            <a:r>
              <a:rPr lang="en-GB" sz="800" strike="noStrike" dirty="0">
                <a:effectLst/>
                <a:latin typeface="BlinkMacSystemFont"/>
              </a:rPr>
              <a:t>[67] Mortality </a:t>
            </a:r>
            <a:r>
              <a:rPr lang="en-GB" sz="800" dirty="0">
                <a:latin typeface="BlinkMacSystemFont"/>
              </a:rPr>
              <a:t>Rate and Characteristics of Deaths Following COVID-19 Vaccination. </a:t>
            </a:r>
            <a:r>
              <a:rPr lang="en-GB" sz="800" strike="noStrike" dirty="0" err="1">
                <a:effectLst/>
                <a:latin typeface="BlinkMacSystemFont"/>
              </a:rPr>
              <a:t>Lv</a:t>
            </a:r>
            <a:r>
              <a:rPr lang="en-GB" sz="800" strike="noStrike" dirty="0">
                <a:effectLst/>
                <a:latin typeface="BlinkMacSystemFont"/>
              </a:rPr>
              <a:t> G, Yuan J, </a:t>
            </a:r>
            <a:r>
              <a:rPr lang="en-GB" sz="800" strike="noStrike" dirty="0" err="1">
                <a:effectLst/>
                <a:latin typeface="BlinkMacSystemFont"/>
              </a:rPr>
              <a:t>Xiong</a:t>
            </a:r>
            <a:r>
              <a:rPr lang="en-GB" sz="800" strike="noStrike" dirty="0">
                <a:effectLst/>
                <a:latin typeface="BlinkMacSystemFont"/>
              </a:rPr>
              <a:t> X, Li </a:t>
            </a:r>
            <a:r>
              <a:rPr lang="en-GB" sz="800" strike="noStrike" dirty="0" err="1">
                <a:effectLst/>
                <a:latin typeface="BlinkMacSystemFont"/>
              </a:rPr>
              <a:t>M.Front</a:t>
            </a:r>
            <a:r>
              <a:rPr lang="en-GB" sz="800" strike="noStrike" dirty="0">
                <a:effectLst/>
                <a:latin typeface="BlinkMacSystemFont"/>
              </a:rPr>
              <a:t> Med (Lausanne). 2021 May 14;8:670370. </a:t>
            </a:r>
            <a:r>
              <a:rPr lang="en-GB" sz="800" strike="noStrike" dirty="0" err="1">
                <a:effectLst/>
                <a:latin typeface="BlinkMacSystemFont"/>
              </a:rPr>
              <a:t>doi</a:t>
            </a:r>
            <a:r>
              <a:rPr lang="en-GB" sz="800" strike="noStrike" dirty="0">
                <a:effectLst/>
                <a:latin typeface="BlinkMacSystemFont"/>
              </a:rPr>
              <a:t>: 10.3389/fmed.2021.670370. </a:t>
            </a:r>
            <a:r>
              <a:rPr lang="en-GB" sz="800" strike="noStrike" dirty="0" err="1">
                <a:effectLst/>
                <a:latin typeface="BlinkMacSystemFont"/>
              </a:rPr>
              <a:t>eCollection</a:t>
            </a:r>
            <a:r>
              <a:rPr lang="en-GB" sz="800" strike="noStrike" dirty="0">
                <a:effectLst/>
                <a:latin typeface="BlinkMacSystemFont"/>
              </a:rPr>
              <a:t> 2021. PMID: 34055843 </a:t>
            </a:r>
          </a:p>
          <a:p>
            <a:r>
              <a:rPr lang="en-GB" sz="800" strike="noStrike" dirty="0">
                <a:effectLst/>
                <a:latin typeface="BlinkMacSystemFont"/>
              </a:rPr>
              <a:t>[68] A systematic review and meta-analysis of published research data on COVID-19 infection fatality rates. Meyerowitz-Katz G, </a:t>
            </a:r>
            <a:r>
              <a:rPr lang="en-GB" sz="800" strike="noStrike" dirty="0" err="1">
                <a:effectLst/>
                <a:latin typeface="BlinkMacSystemFont"/>
              </a:rPr>
              <a:t>Merone</a:t>
            </a:r>
            <a:r>
              <a:rPr lang="en-GB" sz="800" strike="noStrike" dirty="0">
                <a:effectLst/>
                <a:latin typeface="BlinkMacSystemFont"/>
              </a:rPr>
              <a:t> </a:t>
            </a:r>
            <a:r>
              <a:rPr lang="en-GB" sz="800" strike="noStrike" dirty="0" err="1">
                <a:effectLst/>
                <a:latin typeface="BlinkMacSystemFont"/>
              </a:rPr>
              <a:t>L.Int</a:t>
            </a:r>
            <a:r>
              <a:rPr lang="en-GB" sz="800" strike="noStrike" dirty="0">
                <a:effectLst/>
                <a:latin typeface="BlinkMacSystemFont"/>
              </a:rPr>
              <a:t> J Infect Dis. 2020 Dec;101:138-148. </a:t>
            </a:r>
            <a:r>
              <a:rPr lang="en-GB" sz="800" strike="noStrike" dirty="0" err="1">
                <a:effectLst/>
                <a:latin typeface="BlinkMacSystemFont"/>
              </a:rPr>
              <a:t>doi</a:t>
            </a:r>
            <a:r>
              <a:rPr lang="en-GB" sz="800" strike="noStrike" dirty="0">
                <a:effectLst/>
                <a:latin typeface="BlinkMacSystemFont"/>
              </a:rPr>
              <a:t>: 10.1016/j.ijid.2020.09.1464. </a:t>
            </a:r>
            <a:r>
              <a:rPr lang="en-GB" sz="800" strike="noStrike" dirty="0" err="1">
                <a:effectLst/>
                <a:latin typeface="BlinkMacSystemFont"/>
              </a:rPr>
              <a:t>Epub</a:t>
            </a:r>
            <a:r>
              <a:rPr lang="en-GB" sz="800" strike="noStrike" dirty="0">
                <a:effectLst/>
                <a:latin typeface="BlinkMacSystemFont"/>
              </a:rPr>
              <a:t> 2020 Sep 29. PMID: 33007452 </a:t>
            </a:r>
          </a:p>
          <a:p>
            <a:r>
              <a:rPr lang="en-GB" sz="800" dirty="0">
                <a:latin typeface="BlinkMacSystemFont"/>
              </a:rPr>
              <a:t>[69] BNT162b2 mRNA Covid-19 Vaccine in a Nationwide Mass Vaccination Setting. </a:t>
            </a:r>
            <a:r>
              <a:rPr lang="en-GB" sz="800" strike="noStrike" dirty="0">
                <a:effectLst/>
                <a:latin typeface="BlinkMacSystemFont"/>
              </a:rPr>
              <a:t>Dagan N, </a:t>
            </a:r>
            <a:r>
              <a:rPr lang="en-GB" sz="800" strike="noStrike" dirty="0" err="1">
                <a:effectLst/>
                <a:latin typeface="BlinkMacSystemFont"/>
              </a:rPr>
              <a:t>Barda</a:t>
            </a:r>
            <a:r>
              <a:rPr lang="en-GB" sz="800" strike="noStrike" dirty="0">
                <a:effectLst/>
                <a:latin typeface="BlinkMacSystemFont"/>
              </a:rPr>
              <a:t> N, </a:t>
            </a:r>
            <a:r>
              <a:rPr lang="en-GB" sz="800" strike="noStrike" dirty="0" err="1">
                <a:effectLst/>
                <a:latin typeface="BlinkMacSystemFont"/>
              </a:rPr>
              <a:t>Kepten</a:t>
            </a:r>
            <a:r>
              <a:rPr lang="en-GB" sz="800" strike="noStrike" dirty="0">
                <a:effectLst/>
                <a:latin typeface="BlinkMacSystemFont"/>
              </a:rPr>
              <a:t> E, </a:t>
            </a:r>
            <a:r>
              <a:rPr lang="en-GB" sz="800" strike="noStrike" dirty="0" err="1">
                <a:effectLst/>
                <a:latin typeface="BlinkMacSystemFont"/>
              </a:rPr>
              <a:t>Miron</a:t>
            </a:r>
            <a:r>
              <a:rPr lang="en-GB" sz="800" strike="noStrike" dirty="0">
                <a:effectLst/>
                <a:latin typeface="BlinkMacSystemFont"/>
              </a:rPr>
              <a:t> O, </a:t>
            </a:r>
            <a:r>
              <a:rPr lang="en-GB" sz="800" strike="noStrike" dirty="0" err="1">
                <a:effectLst/>
                <a:latin typeface="BlinkMacSystemFont"/>
              </a:rPr>
              <a:t>Perchik</a:t>
            </a:r>
            <a:r>
              <a:rPr lang="en-GB" sz="800" strike="noStrike" dirty="0">
                <a:effectLst/>
                <a:latin typeface="BlinkMacSystemFont"/>
              </a:rPr>
              <a:t> S, Katz MA, </a:t>
            </a:r>
            <a:r>
              <a:rPr lang="en-GB" sz="800" strike="noStrike" dirty="0" err="1">
                <a:effectLst/>
                <a:latin typeface="BlinkMacSystemFont"/>
              </a:rPr>
              <a:t>Hernán</a:t>
            </a:r>
            <a:r>
              <a:rPr lang="en-GB" sz="800" strike="noStrike" dirty="0">
                <a:effectLst/>
                <a:latin typeface="BlinkMacSystemFont"/>
              </a:rPr>
              <a:t> MA, </a:t>
            </a:r>
            <a:r>
              <a:rPr lang="en-GB" sz="800" strike="noStrike" dirty="0" err="1">
                <a:effectLst/>
                <a:latin typeface="BlinkMacSystemFont"/>
              </a:rPr>
              <a:t>Lipsitch</a:t>
            </a:r>
            <a:r>
              <a:rPr lang="en-GB" sz="800" strike="noStrike" dirty="0">
                <a:effectLst/>
                <a:latin typeface="BlinkMacSystemFont"/>
              </a:rPr>
              <a:t> M, Reis B, </a:t>
            </a:r>
            <a:r>
              <a:rPr lang="en-GB" sz="800" strike="noStrike" dirty="0" err="1">
                <a:effectLst/>
                <a:latin typeface="BlinkMacSystemFont"/>
              </a:rPr>
              <a:t>Balicer</a:t>
            </a:r>
            <a:r>
              <a:rPr lang="en-GB" sz="800" strike="noStrike" dirty="0">
                <a:effectLst/>
                <a:latin typeface="BlinkMacSystemFont"/>
              </a:rPr>
              <a:t> RD.N </a:t>
            </a:r>
            <a:r>
              <a:rPr lang="en-GB" sz="800" strike="noStrike" dirty="0" err="1">
                <a:effectLst/>
                <a:latin typeface="BlinkMacSystemFont"/>
              </a:rPr>
              <a:t>Engl</a:t>
            </a:r>
            <a:r>
              <a:rPr lang="en-GB" sz="800" strike="noStrike" dirty="0">
                <a:effectLst/>
                <a:latin typeface="BlinkMacSystemFont"/>
              </a:rPr>
              <a:t> J Med. 2021 Apr 15;384(15):1412-1423. </a:t>
            </a:r>
            <a:r>
              <a:rPr lang="en-GB" sz="800" strike="noStrike" dirty="0" err="1">
                <a:effectLst/>
                <a:latin typeface="BlinkMacSystemFont"/>
              </a:rPr>
              <a:t>doi</a:t>
            </a:r>
            <a:r>
              <a:rPr lang="en-GB" sz="800" strike="noStrike" dirty="0">
                <a:effectLst/>
                <a:latin typeface="BlinkMacSystemFont"/>
              </a:rPr>
              <a:t>: 10.1056/NEJMoa2101765. PMID: 33626250 </a:t>
            </a:r>
          </a:p>
          <a:p>
            <a:pPr marL="136525" indent="-136525">
              <a:buAutoNum type="arabicPeriod"/>
            </a:pPr>
            <a:endParaRPr lang="en-US" sz="800" dirty="0"/>
          </a:p>
        </p:txBody>
      </p:sp>
    </p:spTree>
    <p:extLst>
      <p:ext uri="{BB962C8B-B14F-4D97-AF65-F5344CB8AC3E}">
        <p14:creationId xmlns:p14="http://schemas.microsoft.com/office/powerpoint/2010/main" val="329277845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4</TotalTime>
  <Words>596</Words>
  <Application>Microsoft Office PowerPoint</Application>
  <PresentationFormat>Widescreen</PresentationFormat>
  <Paragraphs>40</Paragraphs>
  <Slides>6</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BlinkMacSystemFont</vt: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Riccardo Masina</dc:creator>
  <cp:lastModifiedBy>MDPI</cp:lastModifiedBy>
  <cp:revision>10</cp:revision>
  <dcterms:created xsi:type="dcterms:W3CDTF">2022-05-26T18:19:53Z</dcterms:created>
  <dcterms:modified xsi:type="dcterms:W3CDTF">2023-01-31T08:31:09Z</dcterms:modified>
</cp:coreProperties>
</file>